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58" r:id="rId2"/>
    <p:sldId id="260" r:id="rId3"/>
    <p:sldId id="261" r:id="rId4"/>
    <p:sldId id="262" r:id="rId5"/>
    <p:sldId id="263" r:id="rId6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00" autoAdjust="0"/>
    <p:restoredTop sz="84170" autoAdjust="0"/>
  </p:normalViewPr>
  <p:slideViewPr>
    <p:cSldViewPr snapToGrid="0">
      <p:cViewPr varScale="1">
        <p:scale>
          <a:sx n="55" d="100"/>
          <a:sy n="55" d="100"/>
        </p:scale>
        <p:origin x="832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EBD2B7-CB57-455A-8B8D-BA0260E06009}" type="datetimeFigureOut">
              <a:rPr lang="en-GB" smtClean="0"/>
              <a:t>19/03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F82548-B1BC-4766-84B7-15BA9F03A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94352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6886CF-8AA4-4C20-A66B-E95DA11850C6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964916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4572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0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fld>
            <a:endParaRPr lang="en-US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25300829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52675" y="1169988"/>
            <a:ext cx="2371725" cy="3160712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BA1303-11F8-4968-96BC-EC80EC90CA0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95846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A97DD45-2459-8F45-8F1B-A0D2427F7B25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93818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B15EF-D336-44DE-92B7-A4EA44ABE45E}" type="datetimeFigureOut">
              <a:rPr lang="en-GB" smtClean="0"/>
              <a:t>19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5EEEE-1C63-45DF-B81C-2BDB42ED8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8620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B15EF-D336-44DE-92B7-A4EA44ABE45E}" type="datetimeFigureOut">
              <a:rPr lang="en-GB" smtClean="0"/>
              <a:t>19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5EEEE-1C63-45DF-B81C-2BDB42ED8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4719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B15EF-D336-44DE-92B7-A4EA44ABE45E}" type="datetimeFigureOut">
              <a:rPr lang="en-GB" smtClean="0"/>
              <a:t>19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5EEEE-1C63-45DF-B81C-2BDB42ED8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7865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B15EF-D336-44DE-92B7-A4EA44ABE45E}" type="datetimeFigureOut">
              <a:rPr lang="en-GB" smtClean="0"/>
              <a:t>19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5EEEE-1C63-45DF-B81C-2BDB42ED8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843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B15EF-D336-44DE-92B7-A4EA44ABE45E}" type="datetimeFigureOut">
              <a:rPr lang="en-GB" smtClean="0"/>
              <a:t>19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5EEEE-1C63-45DF-B81C-2BDB42ED8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0620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B15EF-D336-44DE-92B7-A4EA44ABE45E}" type="datetimeFigureOut">
              <a:rPr lang="en-GB" smtClean="0"/>
              <a:t>19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5EEEE-1C63-45DF-B81C-2BDB42ED8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88846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B15EF-D336-44DE-92B7-A4EA44ABE45E}" type="datetimeFigureOut">
              <a:rPr lang="en-GB" smtClean="0"/>
              <a:t>19/03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5EEEE-1C63-45DF-B81C-2BDB42ED8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29679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B15EF-D336-44DE-92B7-A4EA44ABE45E}" type="datetimeFigureOut">
              <a:rPr lang="en-GB" smtClean="0"/>
              <a:t>19/03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5EEEE-1C63-45DF-B81C-2BDB42ED8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08690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B15EF-D336-44DE-92B7-A4EA44ABE45E}" type="datetimeFigureOut">
              <a:rPr lang="en-GB" smtClean="0"/>
              <a:t>19/03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5EEEE-1C63-45DF-B81C-2BDB42ED8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42144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B15EF-D336-44DE-92B7-A4EA44ABE45E}" type="datetimeFigureOut">
              <a:rPr lang="en-GB" smtClean="0"/>
              <a:t>19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5EEEE-1C63-45DF-B81C-2BDB42ED8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43090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B15EF-D336-44DE-92B7-A4EA44ABE45E}" type="datetimeFigureOut">
              <a:rPr lang="en-GB" smtClean="0"/>
              <a:t>19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5EEEE-1C63-45DF-B81C-2BDB42ED8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77880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7B15EF-D336-44DE-92B7-A4EA44ABE45E}" type="datetimeFigureOut">
              <a:rPr lang="en-GB" smtClean="0"/>
              <a:t>19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45EEEE-1C63-45DF-B81C-2BDB42ED8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9122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tiff"/><Relationship Id="rId13" Type="http://schemas.openxmlformats.org/officeDocument/2006/relationships/image" Target="../media/image25.tiff"/><Relationship Id="rId3" Type="http://schemas.openxmlformats.org/officeDocument/2006/relationships/image" Target="../media/image15.tiff"/><Relationship Id="rId7" Type="http://schemas.openxmlformats.org/officeDocument/2006/relationships/image" Target="../media/image19.tiff"/><Relationship Id="rId12" Type="http://schemas.openxmlformats.org/officeDocument/2006/relationships/image" Target="../media/image24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tiff"/><Relationship Id="rId11" Type="http://schemas.openxmlformats.org/officeDocument/2006/relationships/image" Target="../media/image23.tiff"/><Relationship Id="rId5" Type="http://schemas.openxmlformats.org/officeDocument/2006/relationships/image" Target="../media/image17.tiff"/><Relationship Id="rId10" Type="http://schemas.openxmlformats.org/officeDocument/2006/relationships/image" Target="../media/image22.tiff"/><Relationship Id="rId4" Type="http://schemas.openxmlformats.org/officeDocument/2006/relationships/image" Target="../media/image16.tiff"/><Relationship Id="rId9" Type="http://schemas.openxmlformats.org/officeDocument/2006/relationships/image" Target="../media/image21.tiff"/><Relationship Id="rId14" Type="http://schemas.openxmlformats.org/officeDocument/2006/relationships/image" Target="../media/image26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emf"/><Relationship Id="rId7" Type="http://schemas.openxmlformats.org/officeDocument/2006/relationships/image" Target="../media/image33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emf"/><Relationship Id="rId5" Type="http://schemas.openxmlformats.org/officeDocument/2006/relationships/image" Target="../media/image31.emf"/><Relationship Id="rId4" Type="http://schemas.openxmlformats.org/officeDocument/2006/relationships/image" Target="../media/image3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/>
          <p:cNvGrpSpPr/>
          <p:nvPr/>
        </p:nvGrpSpPr>
        <p:grpSpPr>
          <a:xfrm>
            <a:off x="1739201" y="113243"/>
            <a:ext cx="3437116" cy="3685683"/>
            <a:chOff x="96702" y="4368657"/>
            <a:chExt cx="3437116" cy="3685683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xmlns="" id="{CFF65464-0EB9-4225-B14F-2DFDEA2255E8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96702" y="4544112"/>
              <a:ext cx="3423976" cy="1484437"/>
              <a:chOff x="1533945" y="3087193"/>
              <a:chExt cx="3474720" cy="1643296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xmlns="" id="{4DA98488-6FD6-402F-A340-39CD76597A5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533945" y="3406438"/>
                <a:ext cx="3474720" cy="1324051"/>
              </a:xfrm>
              <a:prstGeom prst="rect">
                <a:avLst/>
              </a:prstGeom>
            </p:spPr>
          </p:pic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xmlns="" id="{2BD99F76-5059-47FA-AE83-2C3A46E31F1F}"/>
                  </a:ext>
                </a:extLst>
              </p:cNvPr>
              <p:cNvGrpSpPr/>
              <p:nvPr/>
            </p:nvGrpSpPr>
            <p:grpSpPr>
              <a:xfrm>
                <a:off x="3844665" y="3087193"/>
                <a:ext cx="1160290" cy="328100"/>
                <a:chOff x="3844665" y="3087193"/>
                <a:chExt cx="1160290" cy="328100"/>
              </a:xfrm>
            </p:grpSpPr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xmlns="" id="{CD753A9F-6E8F-4837-AD44-631FC27D9294}"/>
                    </a:ext>
                  </a:extLst>
                </p:cNvPr>
                <p:cNvSpPr txBox="1"/>
                <p:nvPr/>
              </p:nvSpPr>
              <p:spPr>
                <a:xfrm>
                  <a:off x="4102344" y="3087193"/>
                  <a:ext cx="581257" cy="2534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5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CN1A</a:t>
                  </a:r>
                </a:p>
              </p:txBody>
            </p:sp>
            <p:pic>
              <p:nvPicPr>
                <p:cNvPr id="8" name="Picture 7">
                  <a:extLst>
                    <a:ext uri="{FF2B5EF4-FFF2-40B4-BE49-F238E27FC236}">
                      <a16:creationId xmlns:a16="http://schemas.microsoft.com/office/drawing/2014/main" xmlns="" id="{CB3FCFCA-9D95-483E-82B2-BFD103353E5F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4"/>
                <a:srcRect l="14598" t="9245" b="86118"/>
                <a:stretch/>
              </p:blipFill>
              <p:spPr>
                <a:xfrm>
                  <a:off x="3844665" y="3241499"/>
                  <a:ext cx="1160290" cy="173794"/>
                </a:xfrm>
                <a:prstGeom prst="rect">
                  <a:avLst/>
                </a:prstGeom>
                <a:ln>
                  <a:noFill/>
                </a:ln>
              </p:spPr>
            </p:pic>
          </p:grpSp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xmlns="" id="{F66F72FD-3227-4FEE-8312-FB3C8ECCBD97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/>
              <a:srcRect l="14538" t="6121" b="88707"/>
              <a:stretch/>
            </p:blipFill>
            <p:spPr>
              <a:xfrm>
                <a:off x="2763655" y="3118178"/>
                <a:ext cx="1042416" cy="272098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xmlns="" id="{52DDDC4C-8247-40A8-8CC7-D640CA5D6319}"/>
                  </a:ext>
                </a:extLst>
              </p:cNvPr>
              <p:cNvSpPr txBox="1"/>
              <p:nvPr/>
            </p:nvSpPr>
            <p:spPr>
              <a:xfrm>
                <a:off x="1896753" y="3169664"/>
                <a:ext cx="409608" cy="253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chr2</a:t>
                </a:r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xmlns="" id="{541E12B5-8BEE-42A5-917D-375F2D614757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33069" y="6191012"/>
              <a:ext cx="3400749" cy="1863328"/>
              <a:chOff x="1825231" y="2980531"/>
              <a:chExt cx="2677815" cy="1467219"/>
            </a:xfrm>
          </p:grpSpPr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xmlns="" id="{20D136CB-42EC-40EE-B6ED-51B9825A856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t="5338" b="61522"/>
              <a:stretch/>
            </p:blipFill>
            <p:spPr>
              <a:xfrm>
                <a:off x="2034166" y="2980531"/>
                <a:ext cx="2468880" cy="1090922"/>
              </a:xfrm>
              <a:prstGeom prst="rect">
                <a:avLst/>
              </a:prstGeom>
            </p:spPr>
          </p:pic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xmlns="" id="{2A221A13-19EF-4A8D-8F87-497C4E147719}"/>
                  </a:ext>
                </a:extLst>
              </p:cNvPr>
              <p:cNvGrpSpPr/>
              <p:nvPr/>
            </p:nvGrpSpPr>
            <p:grpSpPr>
              <a:xfrm>
                <a:off x="1825231" y="2991270"/>
                <a:ext cx="1007980" cy="489332"/>
                <a:chOff x="3823344" y="2729255"/>
                <a:chExt cx="1007980" cy="489332"/>
              </a:xfrm>
            </p:grpSpPr>
            <p:grpSp>
              <p:nvGrpSpPr>
                <p:cNvPr id="13" name="Group 12">
                  <a:extLst>
                    <a:ext uri="{FF2B5EF4-FFF2-40B4-BE49-F238E27FC236}">
                      <a16:creationId xmlns:a16="http://schemas.microsoft.com/office/drawing/2014/main" xmlns="" id="{3658B58F-D630-470F-ADBB-2997E4233B75}"/>
                    </a:ext>
                  </a:extLst>
                </p:cNvPr>
                <p:cNvGrpSpPr/>
                <p:nvPr/>
              </p:nvGrpSpPr>
              <p:grpSpPr>
                <a:xfrm>
                  <a:off x="3823344" y="2917582"/>
                  <a:ext cx="1007980" cy="301005"/>
                  <a:chOff x="3620280" y="2626053"/>
                  <a:chExt cx="1007980" cy="301005"/>
                </a:xfrm>
              </p:grpSpPr>
              <p:sp>
                <p:nvSpPr>
                  <p:cNvPr id="15" name="TextBox 14">
                    <a:extLst>
                      <a:ext uri="{FF2B5EF4-FFF2-40B4-BE49-F238E27FC236}">
                        <a16:creationId xmlns:a16="http://schemas.microsoft.com/office/drawing/2014/main" xmlns="" id="{FFA79B86-7F1C-4AAB-9C81-34F540F171C3}"/>
                      </a:ext>
                    </a:extLst>
                  </p:cNvPr>
                  <p:cNvSpPr txBox="1"/>
                  <p:nvPr/>
                </p:nvSpPr>
                <p:spPr>
                  <a:xfrm>
                    <a:off x="3620280" y="2626375"/>
                    <a:ext cx="502531" cy="30068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5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tronger</a:t>
                    </a:r>
                    <a:br>
                      <a:rPr lang="en-US" sz="105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</a:br>
                    <a:r>
                      <a:rPr lang="en-US" sz="105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 cortex</a:t>
                    </a:r>
                  </a:p>
                </p:txBody>
              </p:sp>
              <p:sp>
                <p:nvSpPr>
                  <p:cNvPr id="16" name="TextBox 15">
                    <a:extLst>
                      <a:ext uri="{FF2B5EF4-FFF2-40B4-BE49-F238E27FC236}">
                        <a16:creationId xmlns:a16="http://schemas.microsoft.com/office/drawing/2014/main" xmlns="" id="{70AE4684-5D22-4D80-B7CF-AED25CBDDC74}"/>
                      </a:ext>
                    </a:extLst>
                  </p:cNvPr>
                  <p:cNvSpPr txBox="1"/>
                  <p:nvPr/>
                </p:nvSpPr>
                <p:spPr>
                  <a:xfrm>
                    <a:off x="4136169" y="2626053"/>
                    <a:ext cx="492091" cy="30068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105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tronger</a:t>
                    </a:r>
                  </a:p>
                  <a:p>
                    <a:pPr algn="r"/>
                    <a:r>
                      <a:rPr lang="en-US" sz="105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 lung</a:t>
                    </a:r>
                  </a:p>
                </p:txBody>
              </p:sp>
            </p:grpSp>
            <p:pic>
              <p:nvPicPr>
                <p:cNvPr id="14" name="Picture 13">
                  <a:extLst>
                    <a:ext uri="{FF2B5EF4-FFF2-40B4-BE49-F238E27FC236}">
                      <a16:creationId xmlns:a16="http://schemas.microsoft.com/office/drawing/2014/main" xmlns="" id="{73735B94-B0AC-450C-AFAD-4E436109A03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/>
                <a:srcRect l="92407" b="67776"/>
                <a:stretch/>
              </p:blipFill>
              <p:spPr>
                <a:xfrm rot="16200000">
                  <a:off x="4238549" y="2414729"/>
                  <a:ext cx="193907" cy="822959"/>
                </a:xfrm>
                <a:prstGeom prst="rect">
                  <a:avLst/>
                </a:prstGeom>
              </p:spPr>
            </p:pic>
          </p:grp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xmlns="" id="{B2018820-EB6D-4525-B478-F9A4CAF1EA79}"/>
                  </a:ext>
                </a:extLst>
              </p:cNvPr>
              <p:cNvSpPr/>
              <p:nvPr/>
            </p:nvSpPr>
            <p:spPr>
              <a:xfrm>
                <a:off x="2742470" y="4280351"/>
                <a:ext cx="1247779" cy="1673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/>
              </a:p>
            </p:txBody>
          </p:sp>
        </p:grp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xmlns="" id="{ED50517C-D235-4C26-B625-010C7C951DC6}"/>
                </a:ext>
              </a:extLst>
            </p:cNvPr>
            <p:cNvSpPr/>
            <p:nvPr/>
          </p:nvSpPr>
          <p:spPr>
            <a:xfrm>
              <a:off x="144113" y="4368657"/>
              <a:ext cx="293852" cy="34937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r>
                <a:rPr lang="en-US" sz="110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xmlns="" id="{ED50517C-D235-4C26-B625-010C7C951DC6}"/>
                </a:ext>
              </a:extLst>
            </p:cNvPr>
            <p:cNvSpPr/>
            <p:nvPr/>
          </p:nvSpPr>
          <p:spPr>
            <a:xfrm>
              <a:off x="142211" y="6029965"/>
              <a:ext cx="293852" cy="34937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t"/>
            <a:lstStyle/>
            <a:p>
              <a:r>
                <a:rPr lang="en-US" sz="110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pic>
        <p:nvPicPr>
          <p:cNvPr id="19" name="Picture 18">
            <a:extLst>
              <a:ext uri="{FF2B5EF4-FFF2-40B4-BE49-F238E27FC236}">
                <a16:creationId xmlns:a16="http://schemas.microsoft.com/office/drawing/2014/main" xmlns="" id="{5C44FF58-7865-644E-BC58-7ABBD10F46A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791360" y="3845802"/>
            <a:ext cx="1042005" cy="1042005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xmlns="" id="{63B9EDA5-C27F-8E4F-9F17-21C727DDF98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936876" y="3841457"/>
            <a:ext cx="1072624" cy="1072624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xmlns="" id="{4B1C347E-83FF-FD4F-B22A-A3E329EE61D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124344" y="3872076"/>
            <a:ext cx="1042005" cy="1042005"/>
          </a:xfrm>
          <a:prstGeom prst="rect">
            <a:avLst/>
          </a:prstGeom>
        </p:spPr>
      </p:pic>
      <p:graphicFrame>
        <p:nvGraphicFramePr>
          <p:cNvPr id="22" name="Table 21">
            <a:extLst>
              <a:ext uri="{FF2B5EF4-FFF2-40B4-BE49-F238E27FC236}">
                <a16:creationId xmlns:a16="http://schemas.microsoft.com/office/drawing/2014/main" xmlns="" id="{430C5743-D915-C14F-BA05-2D800DD1FC7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99463113"/>
              </p:ext>
            </p:extLst>
          </p:nvPr>
        </p:nvGraphicFramePr>
        <p:xfrm>
          <a:off x="1645672" y="3706280"/>
          <a:ext cx="3629811" cy="386053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09937">
                  <a:extLst>
                    <a:ext uri="{9D8B030D-6E8A-4147-A177-3AD203B41FA5}">
                      <a16:colId xmlns:a16="http://schemas.microsoft.com/office/drawing/2014/main" xmlns="" val="2509909292"/>
                    </a:ext>
                  </a:extLst>
                </a:gridCol>
                <a:gridCol w="1209937">
                  <a:extLst>
                    <a:ext uri="{9D8B030D-6E8A-4147-A177-3AD203B41FA5}">
                      <a16:colId xmlns:a16="http://schemas.microsoft.com/office/drawing/2014/main" xmlns="" val="2119262153"/>
                    </a:ext>
                  </a:extLst>
                </a:gridCol>
                <a:gridCol w="1209937">
                  <a:extLst>
                    <a:ext uri="{9D8B030D-6E8A-4147-A177-3AD203B41FA5}">
                      <a16:colId xmlns:a16="http://schemas.microsoft.com/office/drawing/2014/main" xmlns="" val="3418880090"/>
                    </a:ext>
                  </a:extLst>
                </a:gridCol>
              </a:tblGrid>
              <a:tr h="1332926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FC vs. HC</a:t>
                      </a:r>
                    </a:p>
                  </a:txBody>
                  <a:tcPr marL="50638" marR="50638" marT="25319" marB="25319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ght Ventricle (RV)</a:t>
                      </a:r>
                    </a:p>
                  </a:txBody>
                  <a:tcPr marL="50638" marR="50638" marT="25319" marB="25319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FC vs. RV</a:t>
                      </a:r>
                    </a:p>
                  </a:txBody>
                  <a:tcPr marL="50638" marR="50638" marT="25319" marB="25319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3062110"/>
                  </a:ext>
                </a:extLst>
              </a:tr>
              <a:tr h="1363980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ppocampus</a:t>
                      </a:r>
                    </a:p>
                  </a:txBody>
                  <a:tcPr marL="50638" marR="50638" marT="25319" marB="25319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-Frontal Cortex </a:t>
                      </a:r>
                    </a:p>
                  </a:txBody>
                  <a:tcPr marL="50638" marR="50638" marT="25319" marB="25319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ng</a:t>
                      </a:r>
                    </a:p>
                  </a:txBody>
                  <a:tcPr marL="50638" marR="50638" marT="25319" marB="25319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06215169"/>
                  </a:ext>
                </a:extLst>
              </a:tr>
              <a:tr h="1163632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FC vs. Pancreas</a:t>
                      </a:r>
                    </a:p>
                  </a:txBody>
                  <a:tcPr marL="50638" marR="50638" marT="25319" marB="25319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ncreas</a:t>
                      </a:r>
                    </a:p>
                  </a:txBody>
                  <a:tcPr marL="50638" marR="50638" marT="25319" marB="25319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FC vs. Lung</a:t>
                      </a:r>
                    </a:p>
                  </a:txBody>
                  <a:tcPr marL="50638" marR="50638" marT="25319" marB="25319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4003678205"/>
                  </a:ext>
                </a:extLst>
              </a:tr>
            </a:tbl>
          </a:graphicData>
        </a:graphic>
      </p:graphicFrame>
      <p:pic>
        <p:nvPicPr>
          <p:cNvPr id="23" name="Picture 22">
            <a:extLst>
              <a:ext uri="{FF2B5EF4-FFF2-40B4-BE49-F238E27FC236}">
                <a16:creationId xmlns:a16="http://schemas.microsoft.com/office/drawing/2014/main" xmlns="" id="{C6F2C262-3589-DC40-A445-29C99343543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793422" y="5194276"/>
            <a:ext cx="1041270" cy="104127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xmlns="" id="{6D514F30-0636-B347-ABB4-C1AF22C7C74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936876" y="5194276"/>
            <a:ext cx="1041270" cy="104127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xmlns="" id="{861FC75B-7AB1-714E-B6FE-58F756E42CD5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124344" y="5177703"/>
            <a:ext cx="1042005" cy="1042005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xmlns="" id="{5BA38C29-D4A0-9F46-84A4-633E1CD9702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787883" y="6573714"/>
            <a:ext cx="1045482" cy="1045482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xmlns="" id="{A1AC360B-A03D-144C-96B5-C1FE3DDA9496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936876" y="6573714"/>
            <a:ext cx="1041270" cy="104127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xmlns="" id="{8C5B2AA1-302A-854E-86C5-A63733126EE7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124344" y="6575109"/>
            <a:ext cx="1042005" cy="1042005"/>
          </a:xfrm>
          <a:prstGeom prst="rect">
            <a:avLst/>
          </a:prstGeom>
        </p:spPr>
      </p:pic>
      <p:sp>
        <p:nvSpPr>
          <p:cNvPr id="29" name="Rectangle 28">
            <a:extLst>
              <a:ext uri="{FF2B5EF4-FFF2-40B4-BE49-F238E27FC236}">
                <a16:creationId xmlns:a16="http://schemas.microsoft.com/office/drawing/2014/main" xmlns="" id="{ED50517C-D235-4C26-B625-010C7C951DC6}"/>
              </a:ext>
            </a:extLst>
          </p:cNvPr>
          <p:cNvSpPr/>
          <p:nvPr/>
        </p:nvSpPr>
        <p:spPr>
          <a:xfrm>
            <a:off x="1750231" y="3495724"/>
            <a:ext cx="293852" cy="34937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US" sz="11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285716" y="7731872"/>
            <a:ext cx="6260859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: Tissue and brain regional differences in chromatin conformation. </a:t>
            </a:r>
          </a:p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(A) Hi-C contact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heatmap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showing chromosomal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neighborhood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of SCN1A at different ranges. (B) Contrasting differential Hi-C contact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heatmap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showing differences between PFC and lung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C) Hi-C contact map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eatmap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t 40-kb resolution for a 5-Mb region around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SCN1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gene. In the central rows and columns are the absolute contact maps, while the corner plots represent the differential contact maps between pre-frontal cortex (PFC) and the indicated tissue. For the latter, red color indicates stronger contacts in PFC in relation to the other tissue, and blue color the opposite.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42535208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879"/>
          <a:stretch/>
        </p:blipFill>
        <p:spPr>
          <a:xfrm>
            <a:off x="1052354" y="720634"/>
            <a:ext cx="1554660" cy="129779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553"/>
          <a:stretch/>
        </p:blipFill>
        <p:spPr>
          <a:xfrm>
            <a:off x="1050842" y="3419706"/>
            <a:ext cx="1556172" cy="130873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682"/>
          <a:stretch/>
        </p:blipFill>
        <p:spPr>
          <a:xfrm>
            <a:off x="2861130" y="727410"/>
            <a:ext cx="1540958" cy="129779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991"/>
          <a:stretch/>
        </p:blipFill>
        <p:spPr>
          <a:xfrm>
            <a:off x="2879319" y="3419706"/>
            <a:ext cx="1548638" cy="130873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223"/>
          <a:stretch/>
        </p:blipFill>
        <p:spPr>
          <a:xfrm>
            <a:off x="4703984" y="727410"/>
            <a:ext cx="1514656" cy="129779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9607"/>
          <a:stretch/>
        </p:blipFill>
        <p:spPr>
          <a:xfrm>
            <a:off x="4703917" y="3419706"/>
            <a:ext cx="1555228" cy="1308736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270734" y="1129465"/>
            <a:ext cx="8092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Membrane</a:t>
            </a:r>
            <a:b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fraction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88377" y="3840607"/>
            <a:ext cx="897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Cytoplasmic</a:t>
            </a:r>
            <a:b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fraction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558291" y="416015"/>
            <a:ext cx="5905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Cortex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176877" y="419202"/>
            <a:ext cx="9499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Hippocampus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041947" y="422783"/>
            <a:ext cx="8301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Cerebellum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803612" y="705767"/>
            <a:ext cx="373591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5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98755" y="884772"/>
            <a:ext cx="366013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805784" y="808309"/>
            <a:ext cx="366013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842074" y="1452660"/>
            <a:ext cx="316757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409844" y="1142487"/>
            <a:ext cx="316757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2282690" y="1238698"/>
            <a:ext cx="491049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latin typeface="Arial" panose="020B0604020202020204" pitchFamily="34" charset="0"/>
                <a:cs typeface="Arial" panose="020B0604020202020204" pitchFamily="34" charset="0"/>
              </a:rPr>
              <a:t>B-actin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810001" y="1195486"/>
            <a:ext cx="316757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682848" y="1291696"/>
            <a:ext cx="491049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latin typeface="Arial" panose="020B0604020202020204" pitchFamily="34" charset="0"/>
                <a:cs typeface="Arial" panose="020B0604020202020204" pitchFamily="34" charset="0"/>
              </a:rPr>
              <a:t>B-actin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570061" y="1595119"/>
            <a:ext cx="6311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2614010" y="685358"/>
            <a:ext cx="373591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5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Picture 4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8404" y="4728442"/>
            <a:ext cx="1126254" cy="1151421"/>
          </a:xfrm>
          <a:prstGeom prst="rect">
            <a:avLst/>
          </a:prstGeom>
        </p:spPr>
      </p:pic>
      <p:pic>
        <p:nvPicPr>
          <p:cNvPr id="42" name="Picture 4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8404" y="2067598"/>
            <a:ext cx="1126254" cy="1151421"/>
          </a:xfrm>
          <a:prstGeom prst="rect">
            <a:avLst/>
          </a:prstGeom>
        </p:spPr>
      </p:pic>
      <p:pic>
        <p:nvPicPr>
          <p:cNvPr id="43" name="Picture 42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9454" y="4728442"/>
            <a:ext cx="1126254" cy="1151421"/>
          </a:xfrm>
          <a:prstGeom prst="rect">
            <a:avLst/>
          </a:prstGeom>
        </p:spPr>
      </p:pic>
      <p:pic>
        <p:nvPicPr>
          <p:cNvPr id="44" name="Picture 43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4388" y="2018584"/>
            <a:ext cx="1126254" cy="1151421"/>
          </a:xfrm>
          <a:prstGeom prst="rect">
            <a:avLst/>
          </a:prstGeom>
        </p:spPr>
      </p:pic>
      <p:pic>
        <p:nvPicPr>
          <p:cNvPr id="45" name="Picture 44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26409" y="2025200"/>
            <a:ext cx="1126254" cy="1151421"/>
          </a:xfrm>
          <a:prstGeom prst="rect">
            <a:avLst/>
          </a:prstGeom>
        </p:spPr>
      </p:pic>
      <p:pic>
        <p:nvPicPr>
          <p:cNvPr id="46" name="Picture 45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8482" y="4728441"/>
            <a:ext cx="1126254" cy="1151421"/>
          </a:xfrm>
          <a:prstGeom prst="rect">
            <a:avLst/>
          </a:prstGeom>
        </p:spPr>
      </p:pic>
      <p:sp>
        <p:nvSpPr>
          <p:cNvPr id="49" name="TextBox 48"/>
          <p:cNvSpPr txBox="1"/>
          <p:nvPr/>
        </p:nvSpPr>
        <p:spPr>
          <a:xfrm>
            <a:off x="1254663" y="699424"/>
            <a:ext cx="352753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1666296" y="692852"/>
            <a:ext cx="420954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b+/-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2153849" y="698375"/>
            <a:ext cx="398221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b-/-</a:t>
            </a:r>
          </a:p>
        </p:txBody>
      </p:sp>
      <p:cxnSp>
        <p:nvCxnSpPr>
          <p:cNvPr id="53" name="Straight Connector 52"/>
          <p:cNvCxnSpPr/>
          <p:nvPr/>
        </p:nvCxnSpPr>
        <p:spPr>
          <a:xfrm flipV="1">
            <a:off x="1236471" y="865776"/>
            <a:ext cx="334829" cy="40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 flipV="1">
            <a:off x="1698746" y="865776"/>
            <a:ext cx="316775" cy="4448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2157761" y="865775"/>
            <a:ext cx="309977" cy="1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TextBox 96"/>
          <p:cNvSpPr txBox="1"/>
          <p:nvPr/>
        </p:nvSpPr>
        <p:spPr>
          <a:xfrm>
            <a:off x="4454600" y="748205"/>
            <a:ext cx="373591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5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4449743" y="927210"/>
            <a:ext cx="366013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99" name="TextBox 98"/>
          <p:cNvSpPr txBox="1"/>
          <p:nvPr/>
        </p:nvSpPr>
        <p:spPr>
          <a:xfrm>
            <a:off x="4493062" y="1495098"/>
            <a:ext cx="316757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2601453" y="916985"/>
            <a:ext cx="366013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2644772" y="1484873"/>
            <a:ext cx="316757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3069230" y="727301"/>
            <a:ext cx="352753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3480863" y="720729"/>
            <a:ext cx="420954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b+/-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3968416" y="726252"/>
            <a:ext cx="398221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b-/-</a:t>
            </a:r>
          </a:p>
        </p:txBody>
      </p:sp>
      <p:cxnSp>
        <p:nvCxnSpPr>
          <p:cNvPr id="111" name="Straight Connector 110"/>
          <p:cNvCxnSpPr/>
          <p:nvPr/>
        </p:nvCxnSpPr>
        <p:spPr>
          <a:xfrm flipV="1">
            <a:off x="3051038" y="893653"/>
            <a:ext cx="334829" cy="40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Connector 111"/>
          <p:cNvCxnSpPr/>
          <p:nvPr/>
        </p:nvCxnSpPr>
        <p:spPr>
          <a:xfrm flipV="1">
            <a:off x="3513313" y="893653"/>
            <a:ext cx="316775" cy="4448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/>
          <p:cNvCxnSpPr/>
          <p:nvPr/>
        </p:nvCxnSpPr>
        <p:spPr>
          <a:xfrm>
            <a:off x="3972328" y="893652"/>
            <a:ext cx="309977" cy="1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119"/>
          <p:cNvSpPr txBox="1"/>
          <p:nvPr/>
        </p:nvSpPr>
        <p:spPr>
          <a:xfrm>
            <a:off x="4898895" y="741930"/>
            <a:ext cx="352753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21" name="TextBox 120"/>
          <p:cNvSpPr txBox="1"/>
          <p:nvPr/>
        </p:nvSpPr>
        <p:spPr>
          <a:xfrm>
            <a:off x="5310528" y="735358"/>
            <a:ext cx="420954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b+/-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5798081" y="740881"/>
            <a:ext cx="398221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b-/-</a:t>
            </a:r>
          </a:p>
        </p:txBody>
      </p:sp>
      <p:cxnSp>
        <p:nvCxnSpPr>
          <p:cNvPr id="123" name="Straight Connector 122"/>
          <p:cNvCxnSpPr/>
          <p:nvPr/>
        </p:nvCxnSpPr>
        <p:spPr>
          <a:xfrm flipV="1">
            <a:off x="4880703" y="908282"/>
            <a:ext cx="334829" cy="40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123"/>
          <p:cNvCxnSpPr/>
          <p:nvPr/>
        </p:nvCxnSpPr>
        <p:spPr>
          <a:xfrm flipV="1">
            <a:off x="5342978" y="908282"/>
            <a:ext cx="316775" cy="4448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Connector 124"/>
          <p:cNvCxnSpPr/>
          <p:nvPr/>
        </p:nvCxnSpPr>
        <p:spPr>
          <a:xfrm>
            <a:off x="5801993" y="908281"/>
            <a:ext cx="309977" cy="1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TextBox 125"/>
          <p:cNvSpPr txBox="1"/>
          <p:nvPr/>
        </p:nvSpPr>
        <p:spPr>
          <a:xfrm>
            <a:off x="1273310" y="3427382"/>
            <a:ext cx="352753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27" name="TextBox 126"/>
          <p:cNvSpPr txBox="1"/>
          <p:nvPr/>
        </p:nvSpPr>
        <p:spPr>
          <a:xfrm>
            <a:off x="1684943" y="3420810"/>
            <a:ext cx="420954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b+/-</a:t>
            </a:r>
          </a:p>
        </p:txBody>
      </p:sp>
      <p:sp>
        <p:nvSpPr>
          <p:cNvPr id="128" name="TextBox 127"/>
          <p:cNvSpPr txBox="1"/>
          <p:nvPr/>
        </p:nvSpPr>
        <p:spPr>
          <a:xfrm>
            <a:off x="2172496" y="3426333"/>
            <a:ext cx="398221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b-/-</a:t>
            </a:r>
          </a:p>
        </p:txBody>
      </p:sp>
      <p:cxnSp>
        <p:nvCxnSpPr>
          <p:cNvPr id="129" name="Straight Connector 128"/>
          <p:cNvCxnSpPr/>
          <p:nvPr/>
        </p:nvCxnSpPr>
        <p:spPr>
          <a:xfrm flipV="1">
            <a:off x="1255118" y="3593734"/>
            <a:ext cx="334829" cy="40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Connector 129"/>
          <p:cNvCxnSpPr/>
          <p:nvPr/>
        </p:nvCxnSpPr>
        <p:spPr>
          <a:xfrm flipV="1">
            <a:off x="1717393" y="3593734"/>
            <a:ext cx="316775" cy="4448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/>
          <p:cNvCxnSpPr/>
          <p:nvPr/>
        </p:nvCxnSpPr>
        <p:spPr>
          <a:xfrm>
            <a:off x="2176408" y="3593733"/>
            <a:ext cx="309977" cy="1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Box 131"/>
          <p:cNvSpPr txBox="1"/>
          <p:nvPr/>
        </p:nvSpPr>
        <p:spPr>
          <a:xfrm>
            <a:off x="3101680" y="3432905"/>
            <a:ext cx="352753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33" name="TextBox 132"/>
          <p:cNvSpPr txBox="1"/>
          <p:nvPr/>
        </p:nvSpPr>
        <p:spPr>
          <a:xfrm>
            <a:off x="3513313" y="3426333"/>
            <a:ext cx="420954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b+/-</a:t>
            </a:r>
          </a:p>
        </p:txBody>
      </p:sp>
      <p:sp>
        <p:nvSpPr>
          <p:cNvPr id="134" name="TextBox 133"/>
          <p:cNvSpPr txBox="1"/>
          <p:nvPr/>
        </p:nvSpPr>
        <p:spPr>
          <a:xfrm>
            <a:off x="4000866" y="3431856"/>
            <a:ext cx="398221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b-/-</a:t>
            </a:r>
          </a:p>
        </p:txBody>
      </p:sp>
      <p:cxnSp>
        <p:nvCxnSpPr>
          <p:cNvPr id="135" name="Straight Connector 134"/>
          <p:cNvCxnSpPr/>
          <p:nvPr/>
        </p:nvCxnSpPr>
        <p:spPr>
          <a:xfrm flipV="1">
            <a:off x="3083488" y="3599257"/>
            <a:ext cx="334829" cy="40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Connector 135"/>
          <p:cNvCxnSpPr/>
          <p:nvPr/>
        </p:nvCxnSpPr>
        <p:spPr>
          <a:xfrm flipV="1">
            <a:off x="3545763" y="3599257"/>
            <a:ext cx="316775" cy="4448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Connector 136"/>
          <p:cNvCxnSpPr/>
          <p:nvPr/>
        </p:nvCxnSpPr>
        <p:spPr>
          <a:xfrm>
            <a:off x="4004778" y="3599256"/>
            <a:ext cx="309977" cy="1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Box 137"/>
          <p:cNvSpPr txBox="1"/>
          <p:nvPr/>
        </p:nvSpPr>
        <p:spPr>
          <a:xfrm>
            <a:off x="4942343" y="3423513"/>
            <a:ext cx="352753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39" name="TextBox 138"/>
          <p:cNvSpPr txBox="1"/>
          <p:nvPr/>
        </p:nvSpPr>
        <p:spPr>
          <a:xfrm>
            <a:off x="5353976" y="3416941"/>
            <a:ext cx="420954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b+/-</a:t>
            </a:r>
          </a:p>
        </p:txBody>
      </p:sp>
      <p:sp>
        <p:nvSpPr>
          <p:cNvPr id="140" name="TextBox 139"/>
          <p:cNvSpPr txBox="1"/>
          <p:nvPr/>
        </p:nvSpPr>
        <p:spPr>
          <a:xfrm>
            <a:off x="5841529" y="3422464"/>
            <a:ext cx="398221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b-/-</a:t>
            </a:r>
          </a:p>
        </p:txBody>
      </p:sp>
      <p:cxnSp>
        <p:nvCxnSpPr>
          <p:cNvPr id="141" name="Straight Connector 140"/>
          <p:cNvCxnSpPr/>
          <p:nvPr/>
        </p:nvCxnSpPr>
        <p:spPr>
          <a:xfrm flipV="1">
            <a:off x="4924151" y="3589865"/>
            <a:ext cx="334829" cy="40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Connector 141"/>
          <p:cNvCxnSpPr/>
          <p:nvPr/>
        </p:nvCxnSpPr>
        <p:spPr>
          <a:xfrm flipV="1">
            <a:off x="5386426" y="3589865"/>
            <a:ext cx="316775" cy="4448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Connector 142"/>
          <p:cNvCxnSpPr/>
          <p:nvPr/>
        </p:nvCxnSpPr>
        <p:spPr>
          <a:xfrm>
            <a:off x="5845441" y="3589864"/>
            <a:ext cx="309977" cy="1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Box 143"/>
          <p:cNvSpPr txBox="1"/>
          <p:nvPr/>
        </p:nvSpPr>
        <p:spPr>
          <a:xfrm>
            <a:off x="801388" y="3415748"/>
            <a:ext cx="373591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5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796531" y="3594753"/>
            <a:ext cx="366013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46" name="TextBox 145"/>
          <p:cNvSpPr txBox="1"/>
          <p:nvPr/>
        </p:nvSpPr>
        <p:spPr>
          <a:xfrm>
            <a:off x="839850" y="4162641"/>
            <a:ext cx="316757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47" name="TextBox 146"/>
          <p:cNvSpPr txBox="1"/>
          <p:nvPr/>
        </p:nvSpPr>
        <p:spPr>
          <a:xfrm>
            <a:off x="567837" y="4305100"/>
            <a:ext cx="6311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148" name="TextBox 147"/>
          <p:cNvSpPr txBox="1"/>
          <p:nvPr/>
        </p:nvSpPr>
        <p:spPr>
          <a:xfrm>
            <a:off x="2631429" y="3363126"/>
            <a:ext cx="373591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5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2618872" y="3594753"/>
            <a:ext cx="366013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50" name="TextBox 149"/>
          <p:cNvSpPr txBox="1"/>
          <p:nvPr/>
        </p:nvSpPr>
        <p:spPr>
          <a:xfrm>
            <a:off x="2662191" y="4162641"/>
            <a:ext cx="316757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51" name="TextBox 150"/>
          <p:cNvSpPr txBox="1"/>
          <p:nvPr/>
        </p:nvSpPr>
        <p:spPr>
          <a:xfrm>
            <a:off x="4464063" y="3415175"/>
            <a:ext cx="373591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57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4451506" y="3646802"/>
            <a:ext cx="366013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53" name="TextBox 152"/>
          <p:cNvSpPr txBox="1"/>
          <p:nvPr/>
        </p:nvSpPr>
        <p:spPr>
          <a:xfrm>
            <a:off x="4494825" y="4214690"/>
            <a:ext cx="316757" cy="180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75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54" name="TextBox 153"/>
          <p:cNvSpPr txBox="1"/>
          <p:nvPr/>
        </p:nvSpPr>
        <p:spPr>
          <a:xfrm>
            <a:off x="564383" y="461565"/>
            <a:ext cx="3735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5" name="TextBox 154"/>
          <p:cNvSpPr txBox="1"/>
          <p:nvPr/>
        </p:nvSpPr>
        <p:spPr>
          <a:xfrm>
            <a:off x="509813" y="3207684"/>
            <a:ext cx="3735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1852301" y="2336494"/>
            <a:ext cx="253596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38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58" name="TextBox 157"/>
          <p:cNvSpPr txBox="1"/>
          <p:nvPr/>
        </p:nvSpPr>
        <p:spPr>
          <a:xfrm>
            <a:off x="3525055" y="2244126"/>
            <a:ext cx="253596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38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59" name="TextBox 158"/>
          <p:cNvSpPr txBox="1"/>
          <p:nvPr/>
        </p:nvSpPr>
        <p:spPr>
          <a:xfrm>
            <a:off x="5576403" y="2542185"/>
            <a:ext cx="253596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38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60" name="TextBox 159"/>
          <p:cNvSpPr txBox="1"/>
          <p:nvPr/>
        </p:nvSpPr>
        <p:spPr>
          <a:xfrm>
            <a:off x="1987164" y="2571152"/>
            <a:ext cx="322525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385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GB" sz="138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3666265" y="2577884"/>
            <a:ext cx="322525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385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GB" sz="138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2030963" y="5047821"/>
            <a:ext cx="253596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385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63" name="TextBox 162"/>
          <p:cNvSpPr txBox="1"/>
          <p:nvPr/>
        </p:nvSpPr>
        <p:spPr>
          <a:xfrm>
            <a:off x="5386426" y="2303373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Box 163"/>
          <p:cNvSpPr txBox="1"/>
          <p:nvPr/>
        </p:nvSpPr>
        <p:spPr>
          <a:xfrm>
            <a:off x="1871304" y="5042866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TextBox 164"/>
          <p:cNvSpPr txBox="1"/>
          <p:nvPr/>
        </p:nvSpPr>
        <p:spPr>
          <a:xfrm>
            <a:off x="3646125" y="5042865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5404794" y="4992266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TextBox 166"/>
          <p:cNvSpPr txBox="1"/>
          <p:nvPr/>
        </p:nvSpPr>
        <p:spPr>
          <a:xfrm>
            <a:off x="5571823" y="5242879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16331" y="6082718"/>
            <a:ext cx="6406538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2: Western blots of Na</a:t>
            </a:r>
            <a:r>
              <a:rPr lang="en-US" sz="11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.1 (250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-actin (45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) proteins in P29-32 brain lysates, membrane and cytoplasmic fractions ran separately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Membrane fraction western blot for cortex shows decrease in Na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.1 protein abundance in 1b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/-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*P=0.0174) and 1b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/-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**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=0.0014) mice. In the hippocampus there is also a decrease in 1b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/-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*P=0.0445) and 1b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/-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**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=0.0025) mice. In the cerebellum there was a decrease in Na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.1 in 1b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*P=0.0142) compared to WT. B) Cytoplasmic fraction western blot shows a decrease in NaV1.1 in 1b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*P=0.0321) versus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wildtyp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no other significant changes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b</a:t>
            </a:r>
            <a:r>
              <a:rPr lang="en-US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=3,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b</a:t>
            </a:r>
            <a:r>
              <a:rPr lang="en-US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/-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=3,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b</a:t>
            </a:r>
            <a:r>
              <a:rPr lang="en-US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=3. ANOVA with Tukey’s post-hoc, significance is versus WT. Error bars represent mean ± SEM. Bands not at 250 and 45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re non-specific and do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ot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how significant changes between genotypes.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90840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photo, grass, colorful, different&#10;&#10;Description automatically generated">
            <a:extLst>
              <a:ext uri="{FF2B5EF4-FFF2-40B4-BE49-F238E27FC236}">
                <a16:creationId xmlns:a16="http://schemas.microsoft.com/office/drawing/2014/main" xmlns="" id="{3057DF3F-715B-4651-B5D6-37C83004FE5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76"/>
          <a:stretch/>
        </p:blipFill>
        <p:spPr>
          <a:xfrm>
            <a:off x="492768" y="595618"/>
            <a:ext cx="5848642" cy="296274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591396" y="2596434"/>
            <a:ext cx="1809383" cy="92971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Rectangle 4"/>
          <p:cNvSpPr/>
          <p:nvPr/>
        </p:nvSpPr>
        <p:spPr>
          <a:xfrm>
            <a:off x="5224130" y="433909"/>
            <a:ext cx="340242" cy="10480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TextBox 5"/>
          <p:cNvSpPr txBox="1"/>
          <p:nvPr/>
        </p:nvSpPr>
        <p:spPr>
          <a:xfrm>
            <a:off x="5160335" y="370896"/>
            <a:ext cx="4678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b</a:t>
            </a:r>
            <a:r>
              <a:rPr lang="en-GB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GB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265821" y="370896"/>
            <a:ext cx="4678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b</a:t>
            </a:r>
            <a:r>
              <a:rPr lang="en-GB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/-</a:t>
            </a:r>
            <a:endParaRPr lang="en-GB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308305" y="364786"/>
            <a:ext cx="4678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591204" y="3783080"/>
            <a:ext cx="5651770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3: </a:t>
            </a:r>
            <a:r>
              <a:rPr lang="en-GB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Immunofluorescent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analysis of sagittal sections of P28 mice.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WT, heterozygous (1b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/-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and knockout (1b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1b mice (n=3 each genotype) underwent immunohistochemistry (IHC) for Na</a:t>
            </a:r>
            <a:r>
              <a:rPr lang="en-GB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1.1 (green) and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parvalbumin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(red) expression (DAPI shown in blue). No observable difference between WT and 1b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/-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. In 1b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mice Na</a:t>
            </a:r>
            <a:r>
              <a:rPr lang="en-GB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1.1 appears reduced in brainstem (2/3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b</a:t>
            </a:r>
            <a:r>
              <a:rPr lang="en-GB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orpus callosum (3/3) and hippocampus (3/3). No observable difference at the IF level in the cortex. WT in red box presented patchy labelling. Scale bars = 1 mm.</a:t>
            </a:r>
          </a:p>
        </p:txBody>
      </p:sp>
    </p:spTree>
    <p:extLst>
      <p:ext uri="{BB962C8B-B14F-4D97-AF65-F5344CB8AC3E}">
        <p14:creationId xmlns:p14="http://schemas.microsoft.com/office/powerpoint/2010/main" val="36428955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/>
          <p:nvPr/>
        </p:nvPicPr>
        <p:blipFill>
          <a:blip r:embed="rId2"/>
          <a:stretch>
            <a:fillRect/>
          </a:stretch>
        </p:blipFill>
        <p:spPr>
          <a:xfrm>
            <a:off x="559041" y="398414"/>
            <a:ext cx="2178198" cy="1929506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559041" y="2327920"/>
            <a:ext cx="5683348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: Seizure severity following </a:t>
            </a:r>
            <a:r>
              <a:rPr lang="en-GB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ntylenetetrazole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PTZ) administration in C57BL6/N mice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80 mg/kg was chosen to ensure all seizure stages were reached.</a:t>
            </a:r>
          </a:p>
          <a:p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427727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Picture 33">
            <a:extLst>
              <a:ext uri="{FF2B5EF4-FFF2-40B4-BE49-F238E27FC236}">
                <a16:creationId xmlns:a16="http://schemas.microsoft.com/office/drawing/2014/main" xmlns="" id="{A4937579-CBD1-254E-BC7B-A41E4F262B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83773" y="2036360"/>
            <a:ext cx="1583662" cy="1583662"/>
          </a:xfrm>
          <a:prstGeom prst="rect">
            <a:avLst/>
          </a:prstGeom>
        </p:spPr>
      </p:pic>
      <p:graphicFrame>
        <p:nvGraphicFramePr>
          <p:cNvPr id="135" name="Table 134">
            <a:extLst>
              <a:ext uri="{FF2B5EF4-FFF2-40B4-BE49-F238E27FC236}">
                <a16:creationId xmlns:a16="http://schemas.microsoft.com/office/drawing/2014/main" xmlns="" id="{DD753A1B-AD40-2E40-9F95-7EAE9DC152E6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3009493" y="3723689"/>
          <a:ext cx="2665370" cy="113329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00555">
                  <a:extLst>
                    <a:ext uri="{9D8B030D-6E8A-4147-A177-3AD203B41FA5}">
                      <a16:colId xmlns:a16="http://schemas.microsoft.com/office/drawing/2014/main" xmlns="" val="237724956"/>
                    </a:ext>
                  </a:extLst>
                </a:gridCol>
                <a:gridCol w="1208890">
                  <a:extLst>
                    <a:ext uri="{9D8B030D-6E8A-4147-A177-3AD203B41FA5}">
                      <a16:colId xmlns:a16="http://schemas.microsoft.com/office/drawing/2014/main" xmlns="" val="930380065"/>
                    </a:ext>
                  </a:extLst>
                </a:gridCol>
                <a:gridCol w="202981">
                  <a:extLst>
                    <a:ext uri="{9D8B030D-6E8A-4147-A177-3AD203B41FA5}">
                      <a16:colId xmlns:a16="http://schemas.microsoft.com/office/drawing/2014/main" xmlns="" val="1402825208"/>
                    </a:ext>
                  </a:extLst>
                </a:gridCol>
                <a:gridCol w="374388">
                  <a:extLst>
                    <a:ext uri="{9D8B030D-6E8A-4147-A177-3AD203B41FA5}">
                      <a16:colId xmlns:a16="http://schemas.microsoft.com/office/drawing/2014/main" xmlns="" val="1288556842"/>
                    </a:ext>
                  </a:extLst>
                </a:gridCol>
                <a:gridCol w="378556">
                  <a:extLst>
                    <a:ext uri="{9D8B030D-6E8A-4147-A177-3AD203B41FA5}">
                      <a16:colId xmlns:a16="http://schemas.microsoft.com/office/drawing/2014/main" xmlns="" val="2999561547"/>
                    </a:ext>
                  </a:extLst>
                </a:gridCol>
              </a:tblGrid>
              <a:tr h="1416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egory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b-/- </a:t>
                      </a:r>
                      <a:r>
                        <a:rPr lang="en-US" sz="6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d </a:t>
                      </a:r>
                      <a:r>
                        <a:rPr lang="en-US" sz="65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b+/-</a:t>
                      </a:r>
                      <a:r>
                        <a:rPr lang="en-US" sz="65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rms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D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</a:t>
                      </a:r>
                      <a:r>
                        <a:rPr lang="en-US" sz="6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DR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17942935"/>
                  </a:ext>
                </a:extLst>
              </a:tr>
              <a:tr h="1416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:0007218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peptide signal. path.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8E-0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406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84260070"/>
                  </a:ext>
                </a:extLst>
              </a:tr>
              <a:tr h="1416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:0007610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havior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3E-0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869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51472600"/>
                  </a:ext>
                </a:extLst>
              </a:tr>
              <a:tr h="1416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:0045111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med</a:t>
                      </a:r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filament cytoskeleton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3E-0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417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83800176"/>
                  </a:ext>
                </a:extLst>
              </a:tr>
              <a:tr h="1416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:0007186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CR signaling pathway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50E-0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828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78404182"/>
                  </a:ext>
                </a:extLst>
              </a:tr>
              <a:tr h="1416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:0032230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. reg. of syn. trans., GABA.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1E-0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6586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10761058"/>
                  </a:ext>
                </a:extLst>
              </a:tr>
              <a:tr h="1416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:0099536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aptic signaling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2E-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3482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58744496"/>
                  </a:ext>
                </a:extLst>
              </a:tr>
              <a:tr h="1416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:0043005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n projection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9E-0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6058</a:t>
                      </a:r>
                      <a:endParaRPr lang="en-US" sz="6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62033578"/>
                  </a:ext>
                </a:extLst>
              </a:tr>
            </a:tbl>
          </a:graphicData>
        </a:graphic>
      </p:graphicFrame>
      <p:sp>
        <p:nvSpPr>
          <p:cNvPr id="136" name="TextBox 135">
            <a:extLst>
              <a:ext uri="{FF2B5EF4-FFF2-40B4-BE49-F238E27FC236}">
                <a16:creationId xmlns:a16="http://schemas.microsoft.com/office/drawing/2014/main" xmlns="" id="{184F051F-1AE8-3142-9B6F-4A7F804858B9}"/>
              </a:ext>
            </a:extLst>
          </p:cNvPr>
          <p:cNvSpPr txBox="1"/>
          <p:nvPr/>
        </p:nvSpPr>
        <p:spPr>
          <a:xfrm>
            <a:off x="151432" y="151552"/>
            <a:ext cx="432936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xmlns="" id="{83DE1416-40D1-0B4C-80BE-9540BE0B5B6D}"/>
              </a:ext>
            </a:extLst>
          </p:cNvPr>
          <p:cNvSpPr txBox="1"/>
          <p:nvPr/>
        </p:nvSpPr>
        <p:spPr>
          <a:xfrm>
            <a:off x="2828126" y="151552"/>
            <a:ext cx="432936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xmlns="" id="{D6766D73-C685-5548-9DD3-DC076D35208B}"/>
              </a:ext>
            </a:extLst>
          </p:cNvPr>
          <p:cNvSpPr txBox="1"/>
          <p:nvPr/>
        </p:nvSpPr>
        <p:spPr>
          <a:xfrm>
            <a:off x="2828126" y="3370726"/>
            <a:ext cx="432936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xmlns="" id="{12FCDFF9-94DC-0945-A049-7C1A1688B14C}"/>
              </a:ext>
            </a:extLst>
          </p:cNvPr>
          <p:cNvSpPr txBox="1"/>
          <p:nvPr/>
        </p:nvSpPr>
        <p:spPr>
          <a:xfrm>
            <a:off x="2828126" y="2014134"/>
            <a:ext cx="432936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41" name="Group 140">
            <a:extLst>
              <a:ext uri="{FF2B5EF4-FFF2-40B4-BE49-F238E27FC236}">
                <a16:creationId xmlns:a16="http://schemas.microsoft.com/office/drawing/2014/main" xmlns="" id="{C4E67550-F114-394B-972A-6112DE755A06}"/>
              </a:ext>
            </a:extLst>
          </p:cNvPr>
          <p:cNvGrpSpPr/>
          <p:nvPr/>
        </p:nvGrpSpPr>
        <p:grpSpPr>
          <a:xfrm>
            <a:off x="4281858" y="272084"/>
            <a:ext cx="1329264" cy="1682942"/>
            <a:chOff x="4737934" y="2644301"/>
            <a:chExt cx="1329264" cy="1682942"/>
          </a:xfrm>
        </p:grpSpPr>
        <p:grpSp>
          <p:nvGrpSpPr>
            <p:cNvPr id="125" name="Group 124">
              <a:extLst>
                <a:ext uri="{FF2B5EF4-FFF2-40B4-BE49-F238E27FC236}">
                  <a16:creationId xmlns:a16="http://schemas.microsoft.com/office/drawing/2014/main" xmlns="" id="{043B2FE0-1F69-DD41-B293-BA64588B73F6}"/>
                </a:ext>
              </a:extLst>
            </p:cNvPr>
            <p:cNvGrpSpPr/>
            <p:nvPr/>
          </p:nvGrpSpPr>
          <p:grpSpPr>
            <a:xfrm>
              <a:off x="4788112" y="2859425"/>
              <a:ext cx="1279086" cy="1467818"/>
              <a:chOff x="5158690" y="4451200"/>
              <a:chExt cx="1279086" cy="1467818"/>
            </a:xfrm>
          </p:grpSpPr>
          <p:pic>
            <p:nvPicPr>
              <p:cNvPr id="128" name="Picture 127">
                <a:extLst>
                  <a:ext uri="{FF2B5EF4-FFF2-40B4-BE49-F238E27FC236}">
                    <a16:creationId xmlns:a16="http://schemas.microsoft.com/office/drawing/2014/main" xmlns="" id="{4372A95E-4111-A442-9B64-7633550A762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duotone>
                  <a:prstClr val="black"/>
                  <a:schemeClr val="accent1">
                    <a:tint val="45000"/>
                    <a:satMod val="400000"/>
                  </a:schemeClr>
                </a:duotone>
              </a:blip>
              <a:srcRect l="28272" t="3195" b="74596"/>
              <a:stretch/>
            </p:blipFill>
            <p:spPr>
              <a:xfrm>
                <a:off x="5520312" y="4643938"/>
                <a:ext cx="917463" cy="1232552"/>
              </a:xfrm>
              <a:prstGeom prst="rect">
                <a:avLst/>
              </a:prstGeom>
            </p:spPr>
          </p:pic>
          <p:pic>
            <p:nvPicPr>
              <p:cNvPr id="129" name="Picture 128">
                <a:extLst>
                  <a:ext uri="{FF2B5EF4-FFF2-40B4-BE49-F238E27FC236}">
                    <a16:creationId xmlns:a16="http://schemas.microsoft.com/office/drawing/2014/main" xmlns="" id="{9F74E06C-5A7F-974F-9350-2019BAE27DC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duotone>
                  <a:prstClr val="black"/>
                  <a:schemeClr val="accent1">
                    <a:tint val="45000"/>
                    <a:satMod val="400000"/>
                  </a:schemeClr>
                </a:duotone>
              </a:blip>
              <a:srcRect t="1617" b="97559"/>
              <a:stretch/>
            </p:blipFill>
            <p:spPr>
              <a:xfrm>
                <a:off x="5158690" y="4574357"/>
                <a:ext cx="1279086" cy="45719"/>
              </a:xfrm>
              <a:prstGeom prst="rect">
                <a:avLst/>
              </a:prstGeom>
            </p:spPr>
          </p:pic>
          <p:pic>
            <p:nvPicPr>
              <p:cNvPr id="130" name="Picture 129">
                <a:extLst>
                  <a:ext uri="{FF2B5EF4-FFF2-40B4-BE49-F238E27FC236}">
                    <a16:creationId xmlns:a16="http://schemas.microsoft.com/office/drawing/2014/main" xmlns="" id="{7D2ADAA9-4D98-544D-ACA3-E86F2B44ACC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duotone>
                  <a:prstClr val="black"/>
                  <a:schemeClr val="accent1">
                    <a:tint val="45000"/>
                    <a:satMod val="400000"/>
                  </a:schemeClr>
                </a:duotone>
              </a:blip>
              <a:srcRect b="98198"/>
              <a:stretch/>
            </p:blipFill>
            <p:spPr>
              <a:xfrm>
                <a:off x="5158690" y="4451200"/>
                <a:ext cx="1279086" cy="99995"/>
              </a:xfrm>
              <a:prstGeom prst="rect">
                <a:avLst/>
              </a:prstGeom>
            </p:spPr>
          </p:pic>
          <p:sp>
            <p:nvSpPr>
              <p:cNvPr id="131" name="Rectangle 130">
                <a:extLst>
                  <a:ext uri="{FF2B5EF4-FFF2-40B4-BE49-F238E27FC236}">
                    <a16:creationId xmlns:a16="http://schemas.microsoft.com/office/drawing/2014/main" xmlns="" id="{494D6EB2-4FB3-7441-968C-49ED99BE73C4}"/>
                  </a:ext>
                </a:extLst>
              </p:cNvPr>
              <p:cNvSpPr/>
              <p:nvPr/>
            </p:nvSpPr>
            <p:spPr>
              <a:xfrm>
                <a:off x="5399200" y="4552760"/>
                <a:ext cx="961862" cy="2743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2" name="Rectangle 131">
                <a:extLst>
                  <a:ext uri="{FF2B5EF4-FFF2-40B4-BE49-F238E27FC236}">
                    <a16:creationId xmlns:a16="http://schemas.microsoft.com/office/drawing/2014/main" xmlns="" id="{9A4DE7C9-A82F-F64C-A82C-03128D68460A}"/>
                  </a:ext>
                </a:extLst>
              </p:cNvPr>
              <p:cNvSpPr/>
              <p:nvPr/>
            </p:nvSpPr>
            <p:spPr>
              <a:xfrm>
                <a:off x="5399200" y="4547515"/>
                <a:ext cx="961862" cy="3657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33" name="Straight Connector 132">
                <a:extLst>
                  <a:ext uri="{FF2B5EF4-FFF2-40B4-BE49-F238E27FC236}">
                    <a16:creationId xmlns:a16="http://schemas.microsoft.com/office/drawing/2014/main" xmlns="" id="{127C1DAD-9991-0346-9834-96C4CBE93E1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25230" y="4451200"/>
                <a:ext cx="0" cy="1444657"/>
              </a:xfrm>
              <a:prstGeom prst="line">
                <a:avLst/>
              </a:prstGeom>
              <a:ln w="6350"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4" name="Rectangle 133">
                <a:extLst>
                  <a:ext uri="{FF2B5EF4-FFF2-40B4-BE49-F238E27FC236}">
                    <a16:creationId xmlns:a16="http://schemas.microsoft.com/office/drawing/2014/main" xmlns="" id="{36FFA858-18BC-6043-B687-30F6EDAF9415}"/>
                  </a:ext>
                </a:extLst>
              </p:cNvPr>
              <p:cNvSpPr/>
              <p:nvPr/>
            </p:nvSpPr>
            <p:spPr>
              <a:xfrm>
                <a:off x="5317302" y="5871023"/>
                <a:ext cx="961862" cy="4799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xmlns="" id="{8DD9A895-F72A-7142-927F-CE2849DA5417}"/>
                </a:ext>
              </a:extLst>
            </p:cNvPr>
            <p:cNvSpPr txBox="1"/>
            <p:nvPr/>
          </p:nvSpPr>
          <p:spPr>
            <a:xfrm>
              <a:off x="4737934" y="3112259"/>
              <a:ext cx="423245" cy="113877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600" b="1" dirty="0">
                  <a:solidFill>
                    <a:srgbClr val="889EC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_M</a:t>
              </a:r>
            </a:p>
            <a:p>
              <a:pPr algn="r"/>
              <a:endParaRPr lang="en-US" sz="600" b="1" dirty="0">
                <a:solidFill>
                  <a:srgbClr val="889EC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100" b="1" dirty="0">
                <a:solidFill>
                  <a:srgbClr val="889EC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600" b="1" dirty="0">
                  <a:solidFill>
                    <a:srgbClr val="889EC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_M</a:t>
              </a:r>
            </a:p>
            <a:p>
              <a:pPr algn="r"/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3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600" b="1" dirty="0" smtClean="0">
                  <a:solidFill>
                    <a:srgbClr val="5E6E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b+/-_</a:t>
              </a:r>
              <a:r>
                <a:rPr lang="en-US" sz="600" b="1" dirty="0">
                  <a:solidFill>
                    <a:srgbClr val="5E6E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  <a:p>
              <a:pPr algn="r"/>
              <a:endParaRPr lang="en-US" sz="400" b="1" dirty="0">
                <a:solidFill>
                  <a:srgbClr val="5E6E99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300" b="1" dirty="0">
                <a:solidFill>
                  <a:srgbClr val="5E6E99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600" b="1" dirty="0" smtClean="0">
                  <a:solidFill>
                    <a:srgbClr val="5E6E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b+/-_</a:t>
              </a:r>
              <a:r>
                <a:rPr lang="en-US" sz="600" b="1" dirty="0">
                  <a:solidFill>
                    <a:srgbClr val="5E6E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  <a:p>
              <a:pPr algn="r"/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600" b="1" dirty="0" smtClean="0">
                  <a:solidFill>
                    <a:srgbClr val="39445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b-/-_</a:t>
              </a:r>
              <a:r>
                <a:rPr lang="en-US" sz="600" b="1" dirty="0">
                  <a:solidFill>
                    <a:srgbClr val="39445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  <a:p>
              <a:pPr algn="r"/>
              <a:endParaRPr lang="en-US" sz="400" b="1" dirty="0">
                <a:solidFill>
                  <a:srgbClr val="39445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300" b="1" dirty="0">
                <a:solidFill>
                  <a:srgbClr val="39445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600" b="1" dirty="0" smtClean="0">
                  <a:solidFill>
                    <a:srgbClr val="39445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b-/-_</a:t>
              </a:r>
              <a:r>
                <a:rPr lang="en-US" sz="600" b="1" dirty="0">
                  <a:solidFill>
                    <a:srgbClr val="39445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140" name="Rectangle 139">
              <a:extLst>
                <a:ext uri="{FF2B5EF4-FFF2-40B4-BE49-F238E27FC236}">
                  <a16:creationId xmlns:a16="http://schemas.microsoft.com/office/drawing/2014/main" xmlns="" id="{070F28CA-D170-DC47-AE7A-8214333650B1}"/>
                </a:ext>
              </a:extLst>
            </p:cNvPr>
            <p:cNvSpPr/>
            <p:nvPr/>
          </p:nvSpPr>
          <p:spPr>
            <a:xfrm>
              <a:off x="5039837" y="4275624"/>
              <a:ext cx="961862" cy="274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xmlns="" id="{29CDE55E-E629-CC42-A158-CD28DB62CBA8}"/>
                </a:ext>
              </a:extLst>
            </p:cNvPr>
            <p:cNvSpPr txBox="1"/>
            <p:nvPr/>
          </p:nvSpPr>
          <p:spPr>
            <a:xfrm>
              <a:off x="5585500" y="2644301"/>
              <a:ext cx="243721" cy="123111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txBody>
            <a:bodyPr wrap="none" lIns="18288" tIns="0" rIns="18288" bIns="0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1a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xmlns="" id="{AE9CB316-E41F-604E-9836-6E1228833F23}"/>
              </a:ext>
            </a:extLst>
          </p:cNvPr>
          <p:cNvGrpSpPr/>
          <p:nvPr/>
        </p:nvGrpSpPr>
        <p:grpSpPr>
          <a:xfrm>
            <a:off x="2954224" y="272165"/>
            <a:ext cx="1326493" cy="1675484"/>
            <a:chOff x="357236" y="4554917"/>
            <a:chExt cx="1326493" cy="1675484"/>
          </a:xfrm>
        </p:grpSpPr>
        <p:grpSp>
          <p:nvGrpSpPr>
            <p:cNvPr id="115" name="Group 114">
              <a:extLst>
                <a:ext uri="{FF2B5EF4-FFF2-40B4-BE49-F238E27FC236}">
                  <a16:creationId xmlns:a16="http://schemas.microsoft.com/office/drawing/2014/main" xmlns="" id="{B0FD2E0C-6D47-A141-ADC9-08ED1BAA67F6}"/>
                </a:ext>
              </a:extLst>
            </p:cNvPr>
            <p:cNvGrpSpPr/>
            <p:nvPr/>
          </p:nvGrpSpPr>
          <p:grpSpPr>
            <a:xfrm>
              <a:off x="422409" y="4768875"/>
              <a:ext cx="1261320" cy="1444657"/>
              <a:chOff x="3439050" y="4479805"/>
              <a:chExt cx="1261320" cy="1444657"/>
            </a:xfrm>
          </p:grpSpPr>
          <p:pic>
            <p:nvPicPr>
              <p:cNvPr id="118" name="Picture 117">
                <a:extLst>
                  <a:ext uri="{FF2B5EF4-FFF2-40B4-BE49-F238E27FC236}">
                    <a16:creationId xmlns:a16="http://schemas.microsoft.com/office/drawing/2014/main" xmlns="" id="{3B5DDAD7-0624-444C-80EF-2ECB93F94EA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duotone>
                  <a:prstClr val="black"/>
                  <a:schemeClr val="accent1">
                    <a:tint val="45000"/>
                    <a:satMod val="400000"/>
                  </a:schemeClr>
                </a:duotone>
              </a:blip>
              <a:srcRect l="30195" t="2982" b="74489"/>
              <a:stretch/>
            </p:blipFill>
            <p:spPr>
              <a:xfrm>
                <a:off x="3819902" y="4674138"/>
                <a:ext cx="880468" cy="1250324"/>
              </a:xfrm>
              <a:prstGeom prst="rect">
                <a:avLst/>
              </a:prstGeom>
            </p:spPr>
          </p:pic>
          <p:pic>
            <p:nvPicPr>
              <p:cNvPr id="119" name="Picture 118">
                <a:extLst>
                  <a:ext uri="{FF2B5EF4-FFF2-40B4-BE49-F238E27FC236}">
                    <a16:creationId xmlns:a16="http://schemas.microsoft.com/office/drawing/2014/main" xmlns="" id="{02D055BC-0E56-8E49-A5DA-73B61FC4B46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duotone>
                  <a:prstClr val="black"/>
                  <a:schemeClr val="accent1">
                    <a:tint val="45000"/>
                    <a:satMod val="400000"/>
                  </a:schemeClr>
                </a:duotone>
              </a:blip>
              <a:srcRect t="1" b="98317"/>
              <a:stretch/>
            </p:blipFill>
            <p:spPr>
              <a:xfrm>
                <a:off x="3439050" y="4479805"/>
                <a:ext cx="1261320" cy="93356"/>
              </a:xfrm>
              <a:prstGeom prst="rect">
                <a:avLst/>
              </a:prstGeom>
            </p:spPr>
          </p:pic>
          <p:pic>
            <p:nvPicPr>
              <p:cNvPr id="120" name="Picture 119">
                <a:extLst>
                  <a:ext uri="{FF2B5EF4-FFF2-40B4-BE49-F238E27FC236}">
                    <a16:creationId xmlns:a16="http://schemas.microsoft.com/office/drawing/2014/main" xmlns="" id="{469142F2-7BAD-7646-B882-95741A07464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duotone>
                  <a:prstClr val="black"/>
                  <a:schemeClr val="accent1">
                    <a:tint val="45000"/>
                    <a:satMod val="400000"/>
                  </a:schemeClr>
                </a:duotone>
              </a:blip>
              <a:srcRect t="1683" b="97493"/>
              <a:stretch/>
            </p:blipFill>
            <p:spPr>
              <a:xfrm>
                <a:off x="3439050" y="4608032"/>
                <a:ext cx="1261320" cy="45719"/>
              </a:xfrm>
              <a:prstGeom prst="rect">
                <a:avLst/>
              </a:prstGeom>
            </p:spPr>
          </p:pic>
          <p:cxnSp>
            <p:nvCxnSpPr>
              <p:cNvPr id="121" name="Straight Connector 120">
                <a:extLst>
                  <a:ext uri="{FF2B5EF4-FFF2-40B4-BE49-F238E27FC236}">
                    <a16:creationId xmlns:a16="http://schemas.microsoft.com/office/drawing/2014/main" xmlns="" id="{F30CEAD4-577A-FB4A-9D79-E5E87F6151A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98030" y="4479805"/>
                <a:ext cx="0" cy="1444657"/>
              </a:xfrm>
              <a:prstGeom prst="line">
                <a:avLst/>
              </a:prstGeom>
              <a:ln w="6350"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2" name="Rectangle 121">
                <a:extLst>
                  <a:ext uri="{FF2B5EF4-FFF2-40B4-BE49-F238E27FC236}">
                    <a16:creationId xmlns:a16="http://schemas.microsoft.com/office/drawing/2014/main" xmlns="" id="{EE9B778A-992C-8442-872E-40DD84082F03}"/>
                  </a:ext>
                </a:extLst>
              </p:cNvPr>
              <p:cNvSpPr/>
              <p:nvPr/>
            </p:nvSpPr>
            <p:spPr>
              <a:xfrm>
                <a:off x="3756025" y="4647113"/>
                <a:ext cx="123825" cy="3657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3" name="Rectangle 122">
                <a:extLst>
                  <a:ext uri="{FF2B5EF4-FFF2-40B4-BE49-F238E27FC236}">
                    <a16:creationId xmlns:a16="http://schemas.microsoft.com/office/drawing/2014/main" xmlns="" id="{BFEE4A57-A9CF-9547-9B8E-9BB46EE2868D}"/>
                  </a:ext>
                </a:extLst>
              </p:cNvPr>
              <p:cNvSpPr/>
              <p:nvPr/>
            </p:nvSpPr>
            <p:spPr>
              <a:xfrm>
                <a:off x="3975335" y="4584156"/>
                <a:ext cx="123825" cy="2743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xmlns="" id="{14E7340A-582A-5045-8413-F3210626B364}"/>
                </a:ext>
              </a:extLst>
            </p:cNvPr>
            <p:cNvSpPr txBox="1"/>
            <p:nvPr/>
          </p:nvSpPr>
          <p:spPr>
            <a:xfrm>
              <a:off x="357236" y="5031400"/>
              <a:ext cx="423245" cy="112338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600" b="1" dirty="0">
                  <a:solidFill>
                    <a:srgbClr val="889EC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_M</a:t>
              </a:r>
            </a:p>
            <a:p>
              <a:pPr algn="r"/>
              <a:endParaRPr lang="en-US" sz="400" b="1" dirty="0">
                <a:solidFill>
                  <a:srgbClr val="889EC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300" b="1" dirty="0">
                <a:solidFill>
                  <a:srgbClr val="889EC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600" b="1" dirty="0">
                  <a:solidFill>
                    <a:srgbClr val="889EC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_M</a:t>
              </a:r>
            </a:p>
            <a:p>
              <a:pPr algn="r"/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3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600" b="1" dirty="0" smtClean="0">
                  <a:solidFill>
                    <a:srgbClr val="5E6E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b+/-_</a:t>
              </a:r>
              <a:r>
                <a:rPr lang="en-US" sz="600" b="1" dirty="0">
                  <a:solidFill>
                    <a:srgbClr val="5E6E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  <a:p>
              <a:pPr algn="r"/>
              <a:endParaRPr lang="en-US" sz="400" b="1" dirty="0">
                <a:solidFill>
                  <a:srgbClr val="5E6E99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300" b="1" dirty="0">
                <a:solidFill>
                  <a:srgbClr val="5E6E99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600" b="1" dirty="0" smtClean="0">
                  <a:solidFill>
                    <a:srgbClr val="5E6E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b+/-_</a:t>
              </a:r>
              <a:r>
                <a:rPr lang="en-US" sz="600" b="1" dirty="0">
                  <a:solidFill>
                    <a:srgbClr val="5E6E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  <a:p>
              <a:pPr algn="r"/>
              <a:endParaRPr lang="en-US" sz="3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600" b="1" dirty="0" smtClean="0">
                  <a:solidFill>
                    <a:srgbClr val="39445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b-/-_</a:t>
              </a:r>
              <a:r>
                <a:rPr lang="en-US" sz="600" b="1" dirty="0">
                  <a:solidFill>
                    <a:srgbClr val="39445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  <a:p>
              <a:pPr algn="r"/>
              <a:endParaRPr lang="en-US" sz="400" b="1" dirty="0">
                <a:solidFill>
                  <a:srgbClr val="39445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300" b="1" dirty="0">
                <a:solidFill>
                  <a:srgbClr val="39445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600" b="1" dirty="0" smtClean="0">
                  <a:solidFill>
                    <a:srgbClr val="39445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b-/-_</a:t>
              </a:r>
              <a:r>
                <a:rPr lang="en-US" sz="600" b="1" dirty="0">
                  <a:solidFill>
                    <a:srgbClr val="39445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142" name="Rectangle 141">
              <a:extLst>
                <a:ext uri="{FF2B5EF4-FFF2-40B4-BE49-F238E27FC236}">
                  <a16:creationId xmlns:a16="http://schemas.microsoft.com/office/drawing/2014/main" xmlns="" id="{FCADD789-701F-D642-82D8-3F8E16D76179}"/>
                </a:ext>
              </a:extLst>
            </p:cNvPr>
            <p:cNvSpPr/>
            <p:nvPr/>
          </p:nvSpPr>
          <p:spPr>
            <a:xfrm>
              <a:off x="622291" y="6177638"/>
              <a:ext cx="961862" cy="527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xmlns="" id="{00B629B9-6EA8-894A-B312-B966096FED22}"/>
                </a:ext>
              </a:extLst>
            </p:cNvPr>
            <p:cNvSpPr txBox="1"/>
            <p:nvPr/>
          </p:nvSpPr>
          <p:spPr>
            <a:xfrm>
              <a:off x="1103222" y="4554917"/>
              <a:ext cx="248530" cy="123111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txBody>
            <a:bodyPr wrap="none" lIns="18288" tIns="0" rIns="18288" bIns="0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1b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06EA6173-A195-DF41-B03E-0405D1921D42}"/>
              </a:ext>
            </a:extLst>
          </p:cNvPr>
          <p:cNvSpPr txBox="1"/>
          <p:nvPr/>
        </p:nvSpPr>
        <p:spPr>
          <a:xfrm>
            <a:off x="3921394" y="2196046"/>
            <a:ext cx="289017" cy="215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lIns="0" rIns="0" rtlCol="0">
            <a:spAutoFit/>
          </a:bodyPr>
          <a:lstStyle/>
          <a:p>
            <a:pPr algn="ctr"/>
            <a:r>
              <a:rPr lang="en-US" sz="800" dirty="0"/>
              <a:t>n=104</a:t>
            </a: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xmlns="" id="{BB7BA961-5D4A-6048-9473-2FA2E4D68EAD}"/>
              </a:ext>
            </a:extLst>
          </p:cNvPr>
          <p:cNvSpPr/>
          <p:nvPr/>
        </p:nvSpPr>
        <p:spPr>
          <a:xfrm>
            <a:off x="4597447" y="548778"/>
            <a:ext cx="88114" cy="536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xmlns="" id="{0BD72B66-023A-3B47-BA66-745364D903F4}"/>
              </a:ext>
            </a:extLst>
          </p:cNvPr>
          <p:cNvGrpSpPr/>
          <p:nvPr/>
        </p:nvGrpSpPr>
        <p:grpSpPr>
          <a:xfrm>
            <a:off x="147323" y="205803"/>
            <a:ext cx="2728185" cy="4678213"/>
            <a:chOff x="147323" y="205803"/>
            <a:chExt cx="2728185" cy="4678213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xmlns="" id="{F9987105-8401-AB48-AC2B-B722E88ACF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duotone>
                <a:prstClr val="black"/>
                <a:schemeClr val="accent1">
                  <a:tint val="45000"/>
                  <a:satMod val="400000"/>
                </a:schemeClr>
              </a:duotone>
            </a:blip>
            <a:srcRect l="19655" t="5414" b="48316"/>
            <a:stretch/>
          </p:blipFill>
          <p:spPr>
            <a:xfrm>
              <a:off x="735768" y="626099"/>
              <a:ext cx="2077093" cy="4230886"/>
            </a:xfrm>
            <a:prstGeom prst="rect">
              <a:avLst/>
            </a:prstGeom>
          </p:spPr>
        </p:pic>
        <p:grpSp>
          <p:nvGrpSpPr>
            <p:cNvPr id="88" name="Group 87">
              <a:extLst>
                <a:ext uri="{FF2B5EF4-FFF2-40B4-BE49-F238E27FC236}">
                  <a16:creationId xmlns:a16="http://schemas.microsoft.com/office/drawing/2014/main" xmlns="" id="{C96ECEBE-ACC2-EC48-8971-3EE84B691089}"/>
                </a:ext>
              </a:extLst>
            </p:cNvPr>
            <p:cNvGrpSpPr/>
            <p:nvPr/>
          </p:nvGrpSpPr>
          <p:grpSpPr>
            <a:xfrm>
              <a:off x="147323" y="362490"/>
              <a:ext cx="2728185" cy="307486"/>
              <a:chOff x="2024790" y="3560590"/>
              <a:chExt cx="2728185" cy="307486"/>
            </a:xfrm>
          </p:grpSpPr>
          <p:pic>
            <p:nvPicPr>
              <p:cNvPr id="101" name="Picture 100">
                <a:extLst>
                  <a:ext uri="{FF2B5EF4-FFF2-40B4-BE49-F238E27FC236}">
                    <a16:creationId xmlns:a16="http://schemas.microsoft.com/office/drawing/2014/main" xmlns="" id="{F42AD961-D93E-D946-827F-C9C578C1560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duotone>
                  <a:prstClr val="black"/>
                  <a:schemeClr val="accent1">
                    <a:tint val="45000"/>
                    <a:satMod val="400000"/>
                  </a:schemeClr>
                </a:duotone>
              </a:blip>
              <a:srcRect t="3627" b="94566"/>
              <a:stretch/>
            </p:blipFill>
            <p:spPr>
              <a:xfrm>
                <a:off x="2106531" y="3560590"/>
                <a:ext cx="2585215" cy="165253"/>
              </a:xfrm>
              <a:prstGeom prst="rect">
                <a:avLst/>
              </a:prstGeom>
            </p:spPr>
          </p:pic>
          <p:pic>
            <p:nvPicPr>
              <p:cNvPr id="102" name="Picture 101">
                <a:extLst>
                  <a:ext uri="{FF2B5EF4-FFF2-40B4-BE49-F238E27FC236}">
                    <a16:creationId xmlns:a16="http://schemas.microsoft.com/office/drawing/2014/main" xmlns="" id="{1D4693E5-758F-D74B-8570-5AFD2DCCED6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duotone>
                  <a:prstClr val="black"/>
                  <a:schemeClr val="accent1">
                    <a:tint val="45000"/>
                    <a:satMod val="400000"/>
                  </a:schemeClr>
                </a:duotone>
              </a:blip>
              <a:srcRect t="1269" b="97415"/>
              <a:stretch/>
            </p:blipFill>
            <p:spPr>
              <a:xfrm>
                <a:off x="2106531" y="3715207"/>
                <a:ext cx="2585215" cy="120332"/>
              </a:xfrm>
              <a:prstGeom prst="rect">
                <a:avLst/>
              </a:prstGeom>
            </p:spPr>
          </p:pic>
          <p:sp>
            <p:nvSpPr>
              <p:cNvPr id="103" name="Rectangle 102">
                <a:extLst>
                  <a:ext uri="{FF2B5EF4-FFF2-40B4-BE49-F238E27FC236}">
                    <a16:creationId xmlns:a16="http://schemas.microsoft.com/office/drawing/2014/main" xmlns="" id="{C0ED889A-C6F8-2741-BB1A-4DBC419E9DFB}"/>
                  </a:ext>
                </a:extLst>
              </p:cNvPr>
              <p:cNvSpPr/>
              <p:nvPr/>
            </p:nvSpPr>
            <p:spPr>
              <a:xfrm>
                <a:off x="2711811" y="3822357"/>
                <a:ext cx="2041164" cy="4571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4" name="Rectangle 103">
                <a:extLst>
                  <a:ext uri="{FF2B5EF4-FFF2-40B4-BE49-F238E27FC236}">
                    <a16:creationId xmlns:a16="http://schemas.microsoft.com/office/drawing/2014/main" xmlns="" id="{3A562CA2-4F62-7245-A789-DF19D43E5DEF}"/>
                  </a:ext>
                </a:extLst>
              </p:cNvPr>
              <p:cNvSpPr/>
              <p:nvPr/>
            </p:nvSpPr>
            <p:spPr>
              <a:xfrm>
                <a:off x="2024790" y="3632906"/>
                <a:ext cx="333756" cy="7536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5" name="Rectangle 104">
                <a:extLst>
                  <a:ext uri="{FF2B5EF4-FFF2-40B4-BE49-F238E27FC236}">
                    <a16:creationId xmlns:a16="http://schemas.microsoft.com/office/drawing/2014/main" xmlns="" id="{41E25595-0C61-FF4B-856D-7DA2EEA6A4CB}"/>
                  </a:ext>
                </a:extLst>
              </p:cNvPr>
              <p:cNvSpPr/>
              <p:nvPr/>
            </p:nvSpPr>
            <p:spPr>
              <a:xfrm>
                <a:off x="3573597" y="3707733"/>
                <a:ext cx="633277" cy="6233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6" name="Rectangle 105">
                <a:extLst>
                  <a:ext uri="{FF2B5EF4-FFF2-40B4-BE49-F238E27FC236}">
                    <a16:creationId xmlns:a16="http://schemas.microsoft.com/office/drawing/2014/main" xmlns="" id="{B279F27F-42D0-914D-B91D-6BF0FF8E52D3}"/>
                  </a:ext>
                </a:extLst>
              </p:cNvPr>
              <p:cNvSpPr/>
              <p:nvPr/>
            </p:nvSpPr>
            <p:spPr>
              <a:xfrm>
                <a:off x="4081134" y="3669775"/>
                <a:ext cx="504030" cy="5486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7" name="Rectangle 106">
                <a:extLst>
                  <a:ext uri="{FF2B5EF4-FFF2-40B4-BE49-F238E27FC236}">
                    <a16:creationId xmlns:a16="http://schemas.microsoft.com/office/drawing/2014/main" xmlns="" id="{461BDEAD-2BA7-1542-97E7-74FAF026C569}"/>
                  </a:ext>
                </a:extLst>
              </p:cNvPr>
              <p:cNvSpPr/>
              <p:nvPr/>
            </p:nvSpPr>
            <p:spPr>
              <a:xfrm>
                <a:off x="4411662" y="3792154"/>
                <a:ext cx="223838" cy="5689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8" name="Rectangle 107">
                <a:extLst>
                  <a:ext uri="{FF2B5EF4-FFF2-40B4-BE49-F238E27FC236}">
                    <a16:creationId xmlns:a16="http://schemas.microsoft.com/office/drawing/2014/main" xmlns="" id="{1FDDF68D-0049-3E4D-8D84-28F1E459C6E5}"/>
                  </a:ext>
                </a:extLst>
              </p:cNvPr>
              <p:cNvSpPr/>
              <p:nvPr/>
            </p:nvSpPr>
            <p:spPr>
              <a:xfrm>
                <a:off x="3539863" y="3792154"/>
                <a:ext cx="223838" cy="5689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9" name="Rectangle 108">
                <a:extLst>
                  <a:ext uri="{FF2B5EF4-FFF2-40B4-BE49-F238E27FC236}">
                    <a16:creationId xmlns:a16="http://schemas.microsoft.com/office/drawing/2014/main" xmlns="" id="{8AD7963B-3B53-6146-8C42-802C43B34BA7}"/>
                  </a:ext>
                </a:extLst>
              </p:cNvPr>
              <p:cNvSpPr/>
              <p:nvPr/>
            </p:nvSpPr>
            <p:spPr>
              <a:xfrm>
                <a:off x="2670174" y="3769492"/>
                <a:ext cx="840882" cy="8712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0" name="Rectangle 109">
                <a:extLst>
                  <a:ext uri="{FF2B5EF4-FFF2-40B4-BE49-F238E27FC236}">
                    <a16:creationId xmlns:a16="http://schemas.microsoft.com/office/drawing/2014/main" xmlns="" id="{BD5208F2-F767-B245-B080-E0F82BA73E4E}"/>
                  </a:ext>
                </a:extLst>
              </p:cNvPr>
              <p:cNvSpPr/>
              <p:nvPr/>
            </p:nvSpPr>
            <p:spPr>
              <a:xfrm>
                <a:off x="2563783" y="3678771"/>
                <a:ext cx="715991" cy="4571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1" name="Rectangle 110">
                <a:extLst>
                  <a:ext uri="{FF2B5EF4-FFF2-40B4-BE49-F238E27FC236}">
                    <a16:creationId xmlns:a16="http://schemas.microsoft.com/office/drawing/2014/main" xmlns="" id="{2AF62E8B-CF1B-DD40-AD44-7380362AE060}"/>
                  </a:ext>
                </a:extLst>
              </p:cNvPr>
              <p:cNvSpPr/>
              <p:nvPr/>
            </p:nvSpPr>
            <p:spPr>
              <a:xfrm>
                <a:off x="2449511" y="3781494"/>
                <a:ext cx="228600" cy="4572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2" name="Rectangle 111">
                <a:extLst>
                  <a:ext uri="{FF2B5EF4-FFF2-40B4-BE49-F238E27FC236}">
                    <a16:creationId xmlns:a16="http://schemas.microsoft.com/office/drawing/2014/main" xmlns="" id="{72051CE3-0457-A340-9BB9-F49E400D28AE}"/>
                  </a:ext>
                </a:extLst>
              </p:cNvPr>
              <p:cNvSpPr/>
              <p:nvPr/>
            </p:nvSpPr>
            <p:spPr>
              <a:xfrm>
                <a:off x="2363748" y="3769685"/>
                <a:ext cx="223838" cy="9503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3" name="Rectangle 112">
                <a:extLst>
                  <a:ext uri="{FF2B5EF4-FFF2-40B4-BE49-F238E27FC236}">
                    <a16:creationId xmlns:a16="http://schemas.microsoft.com/office/drawing/2014/main" xmlns="" id="{5933688E-D54A-D349-9A02-35B1CC5A4337}"/>
                  </a:ext>
                </a:extLst>
              </p:cNvPr>
              <p:cNvSpPr/>
              <p:nvPr/>
            </p:nvSpPr>
            <p:spPr>
              <a:xfrm>
                <a:off x="2996010" y="3704976"/>
                <a:ext cx="85687" cy="4571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90" name="Group 89">
              <a:extLst>
                <a:ext uri="{FF2B5EF4-FFF2-40B4-BE49-F238E27FC236}">
                  <a16:creationId xmlns:a16="http://schemas.microsoft.com/office/drawing/2014/main" xmlns="" id="{5AA53C2D-2122-C047-9342-BA528FFEF1D3}"/>
                </a:ext>
              </a:extLst>
            </p:cNvPr>
            <p:cNvGrpSpPr/>
            <p:nvPr/>
          </p:nvGrpSpPr>
          <p:grpSpPr>
            <a:xfrm>
              <a:off x="229064" y="234096"/>
              <a:ext cx="2646444" cy="231058"/>
              <a:chOff x="2106531" y="3432196"/>
              <a:chExt cx="2646444" cy="231058"/>
            </a:xfrm>
          </p:grpSpPr>
          <p:pic>
            <p:nvPicPr>
              <p:cNvPr id="92" name="Picture 91">
                <a:extLst>
                  <a:ext uri="{FF2B5EF4-FFF2-40B4-BE49-F238E27FC236}">
                    <a16:creationId xmlns:a16="http://schemas.microsoft.com/office/drawing/2014/main" xmlns="" id="{28883CF5-6316-6443-BA2E-F9069FD669C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duotone>
                  <a:prstClr val="black"/>
                  <a:schemeClr val="accent1">
                    <a:tint val="45000"/>
                    <a:satMod val="400000"/>
                  </a:schemeClr>
                </a:duotone>
              </a:blip>
              <a:srcRect b="98615"/>
              <a:stretch/>
            </p:blipFill>
            <p:spPr>
              <a:xfrm>
                <a:off x="2106531" y="3432196"/>
                <a:ext cx="2585215" cy="126604"/>
              </a:xfrm>
              <a:prstGeom prst="rect">
                <a:avLst/>
              </a:prstGeom>
            </p:spPr>
          </p:pic>
          <p:sp>
            <p:nvSpPr>
              <p:cNvPr id="93" name="Rectangle 92">
                <a:extLst>
                  <a:ext uri="{FF2B5EF4-FFF2-40B4-BE49-F238E27FC236}">
                    <a16:creationId xmlns:a16="http://schemas.microsoft.com/office/drawing/2014/main" xmlns="" id="{0FB7D328-2E58-594E-96C4-61A2B54438C3}"/>
                  </a:ext>
                </a:extLst>
              </p:cNvPr>
              <p:cNvSpPr/>
              <p:nvPr/>
            </p:nvSpPr>
            <p:spPr>
              <a:xfrm>
                <a:off x="3279775" y="3540860"/>
                <a:ext cx="682626" cy="2743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4" name="Rectangle 93">
                <a:extLst>
                  <a:ext uri="{FF2B5EF4-FFF2-40B4-BE49-F238E27FC236}">
                    <a16:creationId xmlns:a16="http://schemas.microsoft.com/office/drawing/2014/main" xmlns="" id="{E14111FA-AEF6-8649-9DDE-8A1907B2B48C}"/>
                  </a:ext>
                </a:extLst>
              </p:cNvPr>
              <p:cNvSpPr/>
              <p:nvPr/>
            </p:nvSpPr>
            <p:spPr>
              <a:xfrm>
                <a:off x="4411662" y="3550384"/>
                <a:ext cx="341313" cy="4571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5" name="Rectangle 94">
                <a:extLst>
                  <a:ext uri="{FF2B5EF4-FFF2-40B4-BE49-F238E27FC236}">
                    <a16:creationId xmlns:a16="http://schemas.microsoft.com/office/drawing/2014/main" xmlns="" id="{BA8B4842-3B41-8244-973F-6BCE882EEC03}"/>
                  </a:ext>
                </a:extLst>
              </p:cNvPr>
              <p:cNvSpPr/>
              <p:nvPr/>
            </p:nvSpPr>
            <p:spPr>
              <a:xfrm>
                <a:off x="2753520" y="3543513"/>
                <a:ext cx="192024" cy="2743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6" name="Rectangle 95">
                <a:extLst>
                  <a:ext uri="{FF2B5EF4-FFF2-40B4-BE49-F238E27FC236}">
                    <a16:creationId xmlns:a16="http://schemas.microsoft.com/office/drawing/2014/main" xmlns="" id="{7864866F-33BA-7A46-8382-B801BF93BFE8}"/>
                  </a:ext>
                </a:extLst>
              </p:cNvPr>
              <p:cNvSpPr/>
              <p:nvPr/>
            </p:nvSpPr>
            <p:spPr>
              <a:xfrm>
                <a:off x="2501505" y="3558487"/>
                <a:ext cx="504030" cy="5486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7" name="Rectangle 96">
                <a:extLst>
                  <a:ext uri="{FF2B5EF4-FFF2-40B4-BE49-F238E27FC236}">
                    <a16:creationId xmlns:a16="http://schemas.microsoft.com/office/drawing/2014/main" xmlns="" id="{188A9C28-57BF-2547-96ED-366D476964CF}"/>
                  </a:ext>
                </a:extLst>
              </p:cNvPr>
              <p:cNvSpPr/>
              <p:nvPr/>
            </p:nvSpPr>
            <p:spPr>
              <a:xfrm>
                <a:off x="3163863" y="3552837"/>
                <a:ext cx="504030" cy="5486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8" name="Rectangle 97">
                <a:extLst>
                  <a:ext uri="{FF2B5EF4-FFF2-40B4-BE49-F238E27FC236}">
                    <a16:creationId xmlns:a16="http://schemas.microsoft.com/office/drawing/2014/main" xmlns="" id="{1269860E-9723-7647-B8B6-BE5E1D85E0BC}"/>
                  </a:ext>
                </a:extLst>
              </p:cNvPr>
              <p:cNvSpPr/>
              <p:nvPr/>
            </p:nvSpPr>
            <p:spPr>
              <a:xfrm>
                <a:off x="3763701" y="3558938"/>
                <a:ext cx="592796" cy="104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9" name="Rectangle 98">
                <a:extLst>
                  <a:ext uri="{FF2B5EF4-FFF2-40B4-BE49-F238E27FC236}">
                    <a16:creationId xmlns:a16="http://schemas.microsoft.com/office/drawing/2014/main" xmlns="" id="{F4C26FCD-FA8B-024B-86F1-1EA6A3EE7177}"/>
                  </a:ext>
                </a:extLst>
              </p:cNvPr>
              <p:cNvSpPr/>
              <p:nvPr/>
            </p:nvSpPr>
            <p:spPr>
              <a:xfrm>
                <a:off x="2352541" y="3528684"/>
                <a:ext cx="223838" cy="5689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0" name="Rectangle 99">
                <a:extLst>
                  <a:ext uri="{FF2B5EF4-FFF2-40B4-BE49-F238E27FC236}">
                    <a16:creationId xmlns:a16="http://schemas.microsoft.com/office/drawing/2014/main" xmlns="" id="{4BDC61E3-B08F-5442-82C2-C136D1E78B95}"/>
                  </a:ext>
                </a:extLst>
              </p:cNvPr>
              <p:cNvSpPr/>
              <p:nvPr/>
            </p:nvSpPr>
            <p:spPr>
              <a:xfrm>
                <a:off x="2476766" y="3601195"/>
                <a:ext cx="223838" cy="5689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xmlns="" id="{C65D58F1-CECE-244D-90E3-D55472EB9D82}"/>
                </a:ext>
              </a:extLst>
            </p:cNvPr>
            <p:cNvSpPr txBox="1"/>
            <p:nvPr/>
          </p:nvSpPr>
          <p:spPr>
            <a:xfrm>
              <a:off x="190014" y="710459"/>
              <a:ext cx="547171" cy="413959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700" b="1" dirty="0">
                  <a:solidFill>
                    <a:srgbClr val="8DA1D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1_F_For</a:t>
              </a:r>
            </a:p>
            <a:p>
              <a:pPr algn="r"/>
              <a:endParaRPr lang="en-US" sz="500" b="1" dirty="0">
                <a:solidFill>
                  <a:srgbClr val="8DA1D8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400" b="1" dirty="0">
                <a:solidFill>
                  <a:srgbClr val="8DA1D8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700" b="1" dirty="0">
                  <a:solidFill>
                    <a:srgbClr val="8DA1D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1_F_Rev</a:t>
              </a:r>
            </a:p>
            <a:p>
              <a:pPr algn="r"/>
              <a:endParaRPr lang="en-US" sz="700" b="1" dirty="0">
                <a:solidFill>
                  <a:srgbClr val="8DA1D8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300" b="1" dirty="0">
                <a:solidFill>
                  <a:srgbClr val="8DA1D8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700" b="1" dirty="0">
                  <a:solidFill>
                    <a:srgbClr val="8DA1D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1_F_For</a:t>
              </a:r>
            </a:p>
            <a:p>
              <a:pPr algn="r"/>
              <a:endParaRPr lang="en-US" sz="700" dirty="0">
                <a:solidFill>
                  <a:srgbClr val="8DA1D8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100" dirty="0">
                <a:solidFill>
                  <a:srgbClr val="8DA1D8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200" dirty="0">
                <a:solidFill>
                  <a:srgbClr val="8DA1D8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700" b="1" dirty="0">
                  <a:solidFill>
                    <a:srgbClr val="8DA1D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1_F_Rev</a:t>
              </a:r>
            </a:p>
            <a:p>
              <a:pPr algn="r"/>
              <a:endParaRPr lang="en-US" sz="1000" b="1" dirty="0">
                <a:solidFill>
                  <a:srgbClr val="889EC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700" b="1" dirty="0">
                  <a:solidFill>
                    <a:srgbClr val="889EC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2_M_For</a:t>
              </a:r>
            </a:p>
            <a:p>
              <a:pPr algn="r"/>
              <a:endParaRPr lang="en-US" sz="600" b="1" dirty="0">
                <a:solidFill>
                  <a:srgbClr val="889EC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500" b="1" dirty="0">
                <a:solidFill>
                  <a:srgbClr val="889EC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700" b="1" dirty="0">
                  <a:solidFill>
                    <a:srgbClr val="889EC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2_M_Rev</a:t>
              </a:r>
            </a:p>
            <a:p>
              <a:pPr algn="r"/>
              <a:endParaRPr lang="en-US" sz="700" b="1" dirty="0">
                <a:solidFill>
                  <a:srgbClr val="889EC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400" b="1" dirty="0">
                <a:solidFill>
                  <a:srgbClr val="889EC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700" b="1" dirty="0">
                  <a:solidFill>
                    <a:srgbClr val="889EC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2_M_For</a:t>
              </a:r>
            </a:p>
            <a:p>
              <a:pPr algn="r"/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700" b="1" dirty="0">
                  <a:solidFill>
                    <a:srgbClr val="889EC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2_M_Rev</a:t>
              </a:r>
            </a:p>
            <a:p>
              <a:pPr algn="r"/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700" b="1" dirty="0" smtClean="0">
                  <a:solidFill>
                    <a:srgbClr val="5E6E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b+/-_</a:t>
              </a:r>
              <a:r>
                <a:rPr lang="en-US" sz="700" b="1" dirty="0" err="1">
                  <a:solidFill>
                    <a:srgbClr val="5E6E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_For</a:t>
              </a:r>
              <a:endParaRPr lang="en-US" sz="700" b="1" dirty="0">
                <a:solidFill>
                  <a:srgbClr val="5E6E99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500" b="1" dirty="0">
                <a:solidFill>
                  <a:srgbClr val="5E6E99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500" b="1" dirty="0">
                <a:solidFill>
                  <a:srgbClr val="5E6E99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700" b="1" dirty="0" smtClean="0">
                  <a:solidFill>
                    <a:srgbClr val="5E6E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b+/-_</a:t>
              </a:r>
              <a:r>
                <a:rPr lang="en-US" sz="700" b="1" dirty="0" err="1">
                  <a:solidFill>
                    <a:srgbClr val="5E6E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_Rev</a:t>
              </a:r>
              <a:endParaRPr lang="en-US" sz="700" b="1" dirty="0">
                <a:solidFill>
                  <a:srgbClr val="5E6E99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1050" b="1" dirty="0">
                <a:solidFill>
                  <a:srgbClr val="5E6E99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700" b="1" dirty="0" smtClean="0">
                  <a:solidFill>
                    <a:srgbClr val="5E6E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b+/-_</a:t>
              </a:r>
              <a:r>
                <a:rPr lang="en-US" sz="700" b="1" dirty="0" err="1">
                  <a:solidFill>
                    <a:srgbClr val="5E6E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_For</a:t>
              </a:r>
              <a:endParaRPr lang="en-US" sz="700" b="1" dirty="0">
                <a:solidFill>
                  <a:srgbClr val="5E6E99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700" b="1" dirty="0" smtClean="0">
                  <a:solidFill>
                    <a:srgbClr val="5E6E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b+/-_</a:t>
              </a:r>
              <a:r>
                <a:rPr lang="en-US" sz="700" b="1" dirty="0" err="1">
                  <a:solidFill>
                    <a:srgbClr val="5E6E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_Rev</a:t>
              </a:r>
              <a:endParaRPr lang="en-US" sz="700" b="1" dirty="0">
                <a:solidFill>
                  <a:srgbClr val="5E6E99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700" b="1" dirty="0" smtClean="0">
                  <a:solidFill>
                    <a:srgbClr val="39445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b-/-_</a:t>
              </a:r>
              <a:r>
                <a:rPr lang="en-US" sz="700" b="1" dirty="0" err="1">
                  <a:solidFill>
                    <a:srgbClr val="39445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_For</a:t>
              </a:r>
              <a:endParaRPr lang="en-US" sz="700" b="1" dirty="0">
                <a:solidFill>
                  <a:srgbClr val="39445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700" b="1" dirty="0">
                <a:solidFill>
                  <a:srgbClr val="39445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300" b="1" dirty="0">
                <a:solidFill>
                  <a:srgbClr val="39445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700" b="1" dirty="0" smtClean="0">
                  <a:solidFill>
                    <a:srgbClr val="39445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b-/-_</a:t>
              </a:r>
              <a:r>
                <a:rPr lang="en-US" sz="700" b="1" dirty="0" err="1">
                  <a:solidFill>
                    <a:srgbClr val="39445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_Rev</a:t>
              </a:r>
              <a:endParaRPr lang="en-US" sz="700" b="1" dirty="0">
                <a:solidFill>
                  <a:srgbClr val="39445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1000" b="1" dirty="0">
                <a:solidFill>
                  <a:srgbClr val="39445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700" b="1" dirty="0" smtClean="0">
                  <a:solidFill>
                    <a:srgbClr val="39445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b-/-_</a:t>
              </a:r>
              <a:r>
                <a:rPr lang="en-US" sz="700" b="1" dirty="0" err="1">
                  <a:solidFill>
                    <a:srgbClr val="39445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_For</a:t>
              </a:r>
              <a:endParaRPr lang="en-US" sz="700" b="1" dirty="0">
                <a:solidFill>
                  <a:srgbClr val="39445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1050" b="1" dirty="0">
                <a:solidFill>
                  <a:srgbClr val="39445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700" b="1" dirty="0" smtClean="0">
                  <a:solidFill>
                    <a:srgbClr val="39445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b-/-_</a:t>
              </a:r>
              <a:r>
                <a:rPr lang="en-US" sz="700" b="1" dirty="0" err="1">
                  <a:solidFill>
                    <a:srgbClr val="39445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_Rev</a:t>
              </a:r>
              <a:endParaRPr lang="en-US" sz="700" b="1" dirty="0">
                <a:solidFill>
                  <a:srgbClr val="39445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xmlns="" id="{799E6FD4-726C-BF41-B0A0-EFE444AF089D}"/>
                </a:ext>
              </a:extLst>
            </p:cNvPr>
            <p:cNvSpPr/>
            <p:nvPr/>
          </p:nvSpPr>
          <p:spPr>
            <a:xfrm>
              <a:off x="576813" y="4838296"/>
              <a:ext cx="228600" cy="4572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xmlns="" id="{C1A5003C-9EFE-9F4A-9253-BA7816DE75E5}"/>
                </a:ext>
              </a:extLst>
            </p:cNvPr>
            <p:cNvSpPr/>
            <p:nvPr/>
          </p:nvSpPr>
          <p:spPr>
            <a:xfrm>
              <a:off x="694289" y="494485"/>
              <a:ext cx="228600" cy="3657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xmlns="" id="{68DA6C7A-26C2-1944-BB30-E46C67F7F318}"/>
                </a:ext>
              </a:extLst>
            </p:cNvPr>
            <p:cNvCxnSpPr>
              <a:cxnSpLocks/>
            </p:cNvCxnSpPr>
            <p:nvPr/>
          </p:nvCxnSpPr>
          <p:spPr>
            <a:xfrm>
              <a:off x="828833" y="205803"/>
              <a:ext cx="0" cy="4651182"/>
            </a:xfrm>
            <a:prstGeom prst="line">
              <a:avLst/>
            </a:prstGeom>
            <a:ln w="9525"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xmlns="" id="{0BD81B73-041C-444B-B93E-C58874430450}"/>
                </a:ext>
              </a:extLst>
            </p:cNvPr>
            <p:cNvSpPr/>
            <p:nvPr/>
          </p:nvSpPr>
          <p:spPr>
            <a:xfrm>
              <a:off x="744216" y="618253"/>
              <a:ext cx="71911" cy="7233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0D696FFE-0E48-0442-A106-3823EAF07159}"/>
                </a:ext>
              </a:extLst>
            </p:cNvPr>
            <p:cNvSpPr txBox="1"/>
            <p:nvPr/>
          </p:nvSpPr>
          <p:spPr>
            <a:xfrm>
              <a:off x="758610" y="620442"/>
              <a:ext cx="98418" cy="738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480" dirty="0">
                  <a:solidFill>
                    <a:srgbClr val="859CD5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 -</a:t>
              </a: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47323" y="5121733"/>
            <a:ext cx="5960721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5: Differential gene expression with </a:t>
            </a:r>
            <a:r>
              <a:rPr lang="en-GB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Scn1a 1b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deletion in P32 hippocampu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. (a) Mouse (mm9)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Scn1a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nd nearby-gene loci for P32 wild-type, 1b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/-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, and 1b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mice. WT1 refers to mice sequenced with the 1b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mutants. WT2 refers to mice sequenced with 1b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/-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mutants. (b) Coverage of the m1b (left) and m1a (right) loci across representative P32 wild-type and mutant mice. (c) Scatterplot of differentially-expressed genes meeting a p-value &lt; 0.05 and fold-change &gt; 1.5 threshold in both P32 heterozygous and homozygous 1b deletion datasets. (d) Table showing select pathways enriched in genes having shared differential-expression in both P32 mutant mouse datasets. Ontologies are biological pathways (BP), molecular function (MF), or cellular component (CC).</a:t>
            </a:r>
          </a:p>
        </p:txBody>
      </p:sp>
    </p:spTree>
    <p:extLst>
      <p:ext uri="{BB962C8B-B14F-4D97-AF65-F5344CB8AC3E}">
        <p14:creationId xmlns:p14="http://schemas.microsoft.com/office/powerpoint/2010/main" val="15948163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3</TotalTime>
  <Words>681</Words>
  <Application>Microsoft Office PowerPoint</Application>
  <PresentationFormat>Letter Paper (8.5x11 in)</PresentationFormat>
  <Paragraphs>214</Paragraphs>
  <Slides>5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ssica Haigh</dc:creator>
  <cp:lastModifiedBy>Jessica Haigh</cp:lastModifiedBy>
  <cp:revision>14</cp:revision>
  <dcterms:created xsi:type="dcterms:W3CDTF">2019-09-05T17:28:47Z</dcterms:created>
  <dcterms:modified xsi:type="dcterms:W3CDTF">2021-03-19T13:13:23Z</dcterms:modified>
</cp:coreProperties>
</file>